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notesMasterIdLst>
    <p:notesMasterId r:id="rId3"/>
  </p:notesMasterIdLst>
  <p:sldIdLst>
    <p:sldId id="732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A43C19AD-523C-2EF7-13A9-511744E68E43}" name="健" initials="健" userId="845497175cb2f617" providerId="Windows Live"/>
  <p188:author id="{E94806F5-F1DD-79F5-3D8D-85F6927CF9C2}" name="Author" initials="A" userId="Author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E44B5D2-5F61-4668-81E7-80AA2B6E01C7}" v="1" dt="2023-03-29T23:07:20.21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4538" autoAdjust="0"/>
    <p:restoredTop sz="89444" autoAdjust="0"/>
  </p:normalViewPr>
  <p:slideViewPr>
    <p:cSldViewPr snapToGrid="0">
      <p:cViewPr varScale="1">
        <p:scale>
          <a:sx n="115" d="100"/>
          <a:sy n="115" d="100"/>
        </p:scale>
        <p:origin x="304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microsoft.com/office/2018/10/relationships/authors" Target="author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健" userId="845497175cb2f617" providerId="LiveId" clId="{26EDA9E8-45E4-490C-BA93-E203ED8BE355}"/>
    <pc:docChg chg="custSel delSld modSld">
      <pc:chgData name="健" userId="845497175cb2f617" providerId="LiveId" clId="{26EDA9E8-45E4-490C-BA93-E203ED8BE355}" dt="2023-03-14T03:08:30.208" v="20" actId="20577"/>
      <pc:docMkLst>
        <pc:docMk/>
      </pc:docMkLst>
      <pc:sldChg chg="addSp modSp mod">
        <pc:chgData name="健" userId="845497175cb2f617" providerId="LiveId" clId="{26EDA9E8-45E4-490C-BA93-E203ED8BE355}" dt="2023-03-14T03:08:17.405" v="17" actId="20577"/>
        <pc:sldMkLst>
          <pc:docMk/>
          <pc:sldMk cId="2787273873" sldId="732"/>
        </pc:sldMkLst>
        <pc:spChg chg="add mod">
          <ac:chgData name="健" userId="845497175cb2f617" providerId="LiveId" clId="{26EDA9E8-45E4-490C-BA93-E203ED8BE355}" dt="2023-03-14T03:08:10.340" v="13"/>
          <ac:spMkLst>
            <pc:docMk/>
            <pc:sldMk cId="2787273873" sldId="732"/>
            <ac:spMk id="2" creationId="{B3203020-206B-F9C7-D819-E053BB6FB2B5}"/>
          </ac:spMkLst>
        </pc:spChg>
        <pc:spChg chg="mod">
          <ac:chgData name="健" userId="845497175cb2f617" providerId="LiveId" clId="{26EDA9E8-45E4-490C-BA93-E203ED8BE355}" dt="2023-03-14T03:08:17.405" v="17" actId="20577"/>
          <ac:spMkLst>
            <pc:docMk/>
            <pc:sldMk cId="2787273873" sldId="732"/>
            <ac:spMk id="10" creationId="{E8920F3F-94E7-39A4-FF20-0415E7A0BBF0}"/>
          </ac:spMkLst>
        </pc:spChg>
      </pc:sldChg>
      <pc:sldChg chg="modSp mod">
        <pc:chgData name="健" userId="845497175cb2f617" providerId="LiveId" clId="{26EDA9E8-45E4-490C-BA93-E203ED8BE355}" dt="2023-03-14T03:08:30.208" v="20" actId="20577"/>
        <pc:sldMkLst>
          <pc:docMk/>
          <pc:sldMk cId="2896534360" sldId="733"/>
        </pc:sldMkLst>
        <pc:spChg chg="mod">
          <ac:chgData name="健" userId="845497175cb2f617" providerId="LiveId" clId="{26EDA9E8-45E4-490C-BA93-E203ED8BE355}" dt="2023-03-14T03:08:30.208" v="20" actId="20577"/>
          <ac:spMkLst>
            <pc:docMk/>
            <pc:sldMk cId="2896534360" sldId="733"/>
            <ac:spMk id="7" creationId="{054B640E-A07D-6DAC-0BFA-7373B4B5D28A}"/>
          </ac:spMkLst>
        </pc:spChg>
      </pc:sldChg>
      <pc:sldChg chg="delSp modSp del mod">
        <pc:chgData name="健" userId="845497175cb2f617" providerId="LiveId" clId="{26EDA9E8-45E4-490C-BA93-E203ED8BE355}" dt="2023-03-14T03:08:25.447" v="18" actId="2696"/>
        <pc:sldMkLst>
          <pc:docMk/>
          <pc:sldMk cId="3904400895" sldId="735"/>
        </pc:sldMkLst>
        <pc:spChg chg="del">
          <ac:chgData name="健" userId="845497175cb2f617" providerId="LiveId" clId="{26EDA9E8-45E4-490C-BA93-E203ED8BE355}" dt="2023-03-14T03:07:16.910" v="1" actId="478"/>
          <ac:spMkLst>
            <pc:docMk/>
            <pc:sldMk cId="3904400895" sldId="735"/>
            <ac:spMk id="7" creationId="{601C477B-84CE-D566-B2FA-46423B53974A}"/>
          </ac:spMkLst>
        </pc:spChg>
        <pc:spChg chg="del">
          <ac:chgData name="健" userId="845497175cb2f617" providerId="LiveId" clId="{26EDA9E8-45E4-490C-BA93-E203ED8BE355}" dt="2023-03-14T03:07:23.301" v="5" actId="478"/>
          <ac:spMkLst>
            <pc:docMk/>
            <pc:sldMk cId="3904400895" sldId="735"/>
            <ac:spMk id="9" creationId="{7B8A0CAC-8258-C374-A9AC-A3D3D44B99BB}"/>
          </ac:spMkLst>
        </pc:spChg>
        <pc:spChg chg="del">
          <ac:chgData name="健" userId="845497175cb2f617" providerId="LiveId" clId="{26EDA9E8-45E4-490C-BA93-E203ED8BE355}" dt="2023-03-14T03:07:16.910" v="1" actId="478"/>
          <ac:spMkLst>
            <pc:docMk/>
            <pc:sldMk cId="3904400895" sldId="735"/>
            <ac:spMk id="17" creationId="{ED4D6A0F-A86E-A2C9-C26D-D91C97C8270E}"/>
          </ac:spMkLst>
        </pc:spChg>
        <pc:spChg chg="del">
          <ac:chgData name="健" userId="845497175cb2f617" providerId="LiveId" clId="{26EDA9E8-45E4-490C-BA93-E203ED8BE355}" dt="2023-03-14T03:07:19.624" v="4" actId="478"/>
          <ac:spMkLst>
            <pc:docMk/>
            <pc:sldMk cId="3904400895" sldId="735"/>
            <ac:spMk id="22" creationId="{AEDF93C0-DFAB-B3CF-03E8-F7D50C08EF19}"/>
          </ac:spMkLst>
        </pc:spChg>
        <pc:spChg chg="del">
          <ac:chgData name="健" userId="845497175cb2f617" providerId="LiveId" clId="{26EDA9E8-45E4-490C-BA93-E203ED8BE355}" dt="2023-03-14T03:07:16.910" v="1" actId="478"/>
          <ac:spMkLst>
            <pc:docMk/>
            <pc:sldMk cId="3904400895" sldId="735"/>
            <ac:spMk id="26" creationId="{50C26033-9B58-DA0F-4246-42D5AC75E4C4}"/>
          </ac:spMkLst>
        </pc:spChg>
        <pc:picChg chg="del">
          <ac:chgData name="健" userId="845497175cb2f617" providerId="LiveId" clId="{26EDA9E8-45E4-490C-BA93-E203ED8BE355}" dt="2023-03-14T03:07:13.361" v="0" actId="478"/>
          <ac:picMkLst>
            <pc:docMk/>
            <pc:sldMk cId="3904400895" sldId="735"/>
            <ac:picMk id="5" creationId="{8FDE8E5F-9ECD-8685-6EE6-02C8AD217CE1}"/>
          </ac:picMkLst>
        </pc:picChg>
        <pc:picChg chg="del">
          <ac:chgData name="健" userId="845497175cb2f617" providerId="LiveId" clId="{26EDA9E8-45E4-490C-BA93-E203ED8BE355}" dt="2023-03-14T03:07:16.910" v="1" actId="478"/>
          <ac:picMkLst>
            <pc:docMk/>
            <pc:sldMk cId="3904400895" sldId="735"/>
            <ac:picMk id="13" creationId="{3F56F953-BA9D-3A78-E379-1A7F72171972}"/>
          </ac:picMkLst>
        </pc:picChg>
        <pc:picChg chg="del mod">
          <ac:chgData name="健" userId="845497175cb2f617" providerId="LiveId" clId="{26EDA9E8-45E4-490C-BA93-E203ED8BE355}" dt="2023-03-14T03:07:18.203" v="3" actId="478"/>
          <ac:picMkLst>
            <pc:docMk/>
            <pc:sldMk cId="3904400895" sldId="735"/>
            <ac:picMk id="16" creationId="{E577DCBF-E016-5DE7-5D96-E029F8F624FB}"/>
          </ac:picMkLst>
        </pc:picChg>
        <pc:picChg chg="del">
          <ac:chgData name="健" userId="845497175cb2f617" providerId="LiveId" clId="{26EDA9E8-45E4-490C-BA93-E203ED8BE355}" dt="2023-03-14T03:07:16.910" v="1" actId="478"/>
          <ac:picMkLst>
            <pc:docMk/>
            <pc:sldMk cId="3904400895" sldId="735"/>
            <ac:picMk id="18" creationId="{52527CAE-4723-6783-D997-BF7C3A603920}"/>
          </ac:picMkLst>
        </pc:picChg>
      </pc:sldChg>
      <pc:sldChg chg="del">
        <pc:chgData name="健" userId="845497175cb2f617" providerId="LiveId" clId="{26EDA9E8-45E4-490C-BA93-E203ED8BE355}" dt="2023-03-14T03:07:30.416" v="6" actId="2696"/>
        <pc:sldMkLst>
          <pc:docMk/>
          <pc:sldMk cId="1221763323" sldId="736"/>
        </pc:sldMkLst>
      </pc:sldChg>
      <pc:sldChg chg="del">
        <pc:chgData name="健" userId="845497175cb2f617" providerId="LiveId" clId="{26EDA9E8-45E4-490C-BA93-E203ED8BE355}" dt="2023-03-14T03:07:32.905" v="7" actId="2696"/>
        <pc:sldMkLst>
          <pc:docMk/>
          <pc:sldMk cId="341717010" sldId="737"/>
        </pc:sldMkLst>
      </pc:sldChg>
      <pc:sldChg chg="del">
        <pc:chgData name="健" userId="845497175cb2f617" providerId="LiveId" clId="{26EDA9E8-45E4-490C-BA93-E203ED8BE355}" dt="2023-03-14T03:07:38.038" v="9" actId="2696"/>
        <pc:sldMkLst>
          <pc:docMk/>
          <pc:sldMk cId="4086761036" sldId="738"/>
        </pc:sldMkLst>
      </pc:sldChg>
      <pc:sldChg chg="del">
        <pc:chgData name="健" userId="845497175cb2f617" providerId="LiveId" clId="{26EDA9E8-45E4-490C-BA93-E203ED8BE355}" dt="2023-03-14T03:07:35.425" v="8" actId="2696"/>
        <pc:sldMkLst>
          <pc:docMk/>
          <pc:sldMk cId="2463354579" sldId="739"/>
        </pc:sldMkLst>
      </pc:sldChg>
      <pc:sldChg chg="del">
        <pc:chgData name="健" userId="845497175cb2f617" providerId="LiveId" clId="{26EDA9E8-45E4-490C-BA93-E203ED8BE355}" dt="2023-03-14T03:07:40.446" v="10" actId="2696"/>
        <pc:sldMkLst>
          <pc:docMk/>
          <pc:sldMk cId="2024489355" sldId="740"/>
        </pc:sldMkLst>
      </pc:sldChg>
      <pc:sldChg chg="del">
        <pc:chgData name="健" userId="845497175cb2f617" providerId="LiveId" clId="{26EDA9E8-45E4-490C-BA93-E203ED8BE355}" dt="2023-03-14T03:07:43.374" v="11" actId="2696"/>
        <pc:sldMkLst>
          <pc:docMk/>
          <pc:sldMk cId="1509419233" sldId="741"/>
        </pc:sldMkLst>
      </pc:sldChg>
      <pc:sldChg chg="del">
        <pc:chgData name="健" userId="845497175cb2f617" providerId="LiveId" clId="{26EDA9E8-45E4-490C-BA93-E203ED8BE355}" dt="2023-03-14T03:07:46.504" v="12" actId="2696"/>
        <pc:sldMkLst>
          <pc:docMk/>
          <pc:sldMk cId="4162826778" sldId="743"/>
        </pc:sldMkLst>
      </pc:sldChg>
    </pc:docChg>
  </pc:docChgLst>
  <pc:docChgLst>
    <pc:chgData name="健" userId="845497175cb2f617" providerId="LiveId" clId="{DA82416F-47BF-4BDB-8A87-54D4516AAFD7}"/>
    <pc:docChg chg="delSld">
      <pc:chgData name="健" userId="845497175cb2f617" providerId="LiveId" clId="{DA82416F-47BF-4BDB-8A87-54D4516AAFD7}" dt="2023-03-30T02:33:08.426" v="3" actId="2696"/>
      <pc:docMkLst>
        <pc:docMk/>
      </pc:docMkLst>
      <pc:sldChg chg="del">
        <pc:chgData name="健" userId="845497175cb2f617" providerId="LiveId" clId="{DA82416F-47BF-4BDB-8A87-54D4516AAFD7}" dt="2023-03-30T02:32:52.006" v="1" actId="2696"/>
        <pc:sldMkLst>
          <pc:docMk/>
          <pc:sldMk cId="2680915516" sldId="258"/>
        </pc:sldMkLst>
      </pc:sldChg>
      <pc:sldChg chg="del">
        <pc:chgData name="健" userId="845497175cb2f617" providerId="LiveId" clId="{DA82416F-47BF-4BDB-8A87-54D4516AAFD7}" dt="2023-03-30T02:32:55.074" v="2" actId="2696"/>
        <pc:sldMkLst>
          <pc:docMk/>
          <pc:sldMk cId="238210136" sldId="692"/>
        </pc:sldMkLst>
      </pc:sldChg>
      <pc:sldChg chg="del">
        <pc:chgData name="健" userId="845497175cb2f617" providerId="LiveId" clId="{DA82416F-47BF-4BDB-8A87-54D4516AAFD7}" dt="2023-03-30T02:33:08.426" v="3" actId="2696"/>
        <pc:sldMkLst>
          <pc:docMk/>
          <pc:sldMk cId="2896534360" sldId="733"/>
        </pc:sldMkLst>
      </pc:sldChg>
      <pc:sldChg chg="del">
        <pc:chgData name="健" userId="845497175cb2f617" providerId="LiveId" clId="{DA82416F-47BF-4BDB-8A87-54D4516AAFD7}" dt="2023-03-30T02:32:49.355" v="0" actId="2696"/>
        <pc:sldMkLst>
          <pc:docMk/>
          <pc:sldMk cId="3596372726" sldId="744"/>
        </pc:sldMkLst>
      </pc:sldChg>
    </pc:docChg>
  </pc:docChgLst>
  <pc:docChgLst>
    <pc:chgData name="健" userId="845497175cb2f617" providerId="LiveId" clId="{164BA8A9-15FA-4B31-8B26-41A9A4BEB697}"/>
    <pc:docChg chg="modSld">
      <pc:chgData name="健" userId="845497175cb2f617" providerId="LiveId" clId="{164BA8A9-15FA-4B31-8B26-41A9A4BEB697}" dt="2023-03-28T06:34:33.577" v="9" actId="13926"/>
      <pc:docMkLst>
        <pc:docMk/>
      </pc:docMkLst>
      <pc:sldChg chg="modSp mod">
        <pc:chgData name="健" userId="845497175cb2f617" providerId="LiveId" clId="{164BA8A9-15FA-4B31-8B26-41A9A4BEB697}" dt="2023-03-28T06:34:33.577" v="9" actId="13926"/>
        <pc:sldMkLst>
          <pc:docMk/>
          <pc:sldMk cId="2896534360" sldId="733"/>
        </pc:sldMkLst>
        <pc:spChg chg="mod">
          <ac:chgData name="健" userId="845497175cb2f617" providerId="LiveId" clId="{164BA8A9-15FA-4B31-8B26-41A9A4BEB697}" dt="2023-03-28T06:34:33.577" v="9" actId="13926"/>
          <ac:spMkLst>
            <pc:docMk/>
            <pc:sldMk cId="2896534360" sldId="733"/>
            <ac:spMk id="12" creationId="{B9966725-7678-E3FF-5C5A-07FDE6523D98}"/>
          </ac:spMkLst>
        </pc:spChg>
      </pc:sldChg>
    </pc:docChg>
  </pc:docChgLst>
  <pc:docChgLst>
    <pc:chgData name="健" userId="845497175cb2f617" providerId="LiveId" clId="{248CE05B-4D93-443E-B6EF-ADB2E83653D1}"/>
    <pc:docChg chg="undo custSel addSld delSld modSld sldOrd">
      <pc:chgData name="健" userId="845497175cb2f617" providerId="LiveId" clId="{248CE05B-4D93-443E-B6EF-ADB2E83653D1}" dt="2023-03-14T00:24:28.870" v="1200" actId="1076"/>
      <pc:docMkLst>
        <pc:docMk/>
      </pc:docMkLst>
      <pc:sldChg chg="modSp mod delCm">
        <pc:chgData name="健" userId="845497175cb2f617" providerId="LiveId" clId="{248CE05B-4D93-443E-B6EF-ADB2E83653D1}" dt="2023-03-02T23:58:13.098" v="214" actId="1076"/>
        <pc:sldMkLst>
          <pc:docMk/>
          <pc:sldMk cId="2680915516" sldId="258"/>
        </pc:sldMkLst>
        <pc:graphicFrameChg chg="mod">
          <ac:chgData name="健" userId="845497175cb2f617" providerId="LiveId" clId="{248CE05B-4D93-443E-B6EF-ADB2E83653D1}" dt="2023-03-02T23:58:13.098" v="214" actId="1076"/>
          <ac:graphicFrameMkLst>
            <pc:docMk/>
            <pc:sldMk cId="2680915516" sldId="258"/>
            <ac:graphicFrameMk id="2" creationId="{C265802E-8BAC-D6E3-03E3-2D9A039E2E7C}"/>
          </ac:graphicFrameMkLst>
        </pc:graphicFrameChg>
        <pc:extLst>
          <p:ext xmlns:p="http://schemas.openxmlformats.org/presentationml/2006/main" uri="{D6D511B9-2390-475A-947B-AFAB55BFBCF1}">
            <pc226:cmChg xmlns:pc226="http://schemas.microsoft.com/office/powerpoint/2022/06/main/command" chg="del">
              <pc226:chgData name="健" userId="845497175cb2f617" providerId="LiveId" clId="{248CE05B-4D93-443E-B6EF-ADB2E83653D1}" dt="2023-01-24T23:56:40.872" v="3"/>
              <pc2:cmMkLst xmlns:pc2="http://schemas.microsoft.com/office/powerpoint/2019/9/main/command">
                <pc:docMk/>
                <pc:sldMk cId="2680915516" sldId="258"/>
                <pc2:cmMk id="{4821BC27-6E52-4DBF-97ED-34A21514BB18}"/>
              </pc2:cmMkLst>
            </pc226:cmChg>
            <pc226:cmChg xmlns:pc226="http://schemas.microsoft.com/office/powerpoint/2022/06/main/command" chg="del">
              <pc226:chgData name="健" userId="845497175cb2f617" providerId="LiveId" clId="{248CE05B-4D93-443E-B6EF-ADB2E83653D1}" dt="2023-01-24T23:56:52.329" v="4"/>
              <pc2:cmMkLst xmlns:pc2="http://schemas.microsoft.com/office/powerpoint/2019/9/main/command">
                <pc:docMk/>
                <pc:sldMk cId="2680915516" sldId="258"/>
                <pc2:cmMk id="{5B851A77-4BD8-4C0B-ACEA-99C249F05A4E}"/>
              </pc2:cmMkLst>
            </pc226:cmChg>
          </p:ext>
        </pc:extLst>
      </pc:sldChg>
      <pc:sldChg chg="delCm">
        <pc:chgData name="健" userId="845497175cb2f617" providerId="LiveId" clId="{248CE05B-4D93-443E-B6EF-ADB2E83653D1}" dt="2023-01-24T23:57:09.702" v="6"/>
        <pc:sldMkLst>
          <pc:docMk/>
          <pc:sldMk cId="238210136" sldId="692"/>
        </pc:sldMkLst>
        <pc:extLst>
          <p:ext xmlns:p="http://schemas.openxmlformats.org/presentationml/2006/main" uri="{D6D511B9-2390-475A-947B-AFAB55BFBCF1}">
            <pc226:cmChg xmlns:pc226="http://schemas.microsoft.com/office/powerpoint/2022/06/main/command" chg="del">
              <pc226:chgData name="健" userId="845497175cb2f617" providerId="LiveId" clId="{248CE05B-4D93-443E-B6EF-ADB2E83653D1}" dt="2023-01-24T23:57:09.702" v="6"/>
              <pc2:cmMkLst xmlns:pc2="http://schemas.microsoft.com/office/powerpoint/2019/9/main/command">
                <pc:docMk/>
                <pc:sldMk cId="238210136" sldId="692"/>
                <pc2:cmMk id="{1F87950E-D0A8-4836-8A21-10B5E7098469}"/>
              </pc2:cmMkLst>
            </pc226:cmChg>
            <pc226:cmChg xmlns:pc226="http://schemas.microsoft.com/office/powerpoint/2022/06/main/command" chg="del">
              <pc226:chgData name="健" userId="845497175cb2f617" providerId="LiveId" clId="{248CE05B-4D93-443E-B6EF-ADB2E83653D1}" dt="2023-01-24T23:57:03.039" v="5"/>
              <pc2:cmMkLst xmlns:pc2="http://schemas.microsoft.com/office/powerpoint/2019/9/main/command">
                <pc:docMk/>
                <pc:sldMk cId="238210136" sldId="692"/>
                <pc2:cmMk id="{6D512ECC-F993-4389-A503-D4BB78528BA4}"/>
              </pc2:cmMkLst>
            </pc226:cmChg>
          </p:ext>
        </pc:extLst>
      </pc:sldChg>
      <pc:sldChg chg="addSp delSp modSp del mod delCm">
        <pc:chgData name="健" userId="845497175cb2f617" providerId="LiveId" clId="{248CE05B-4D93-443E-B6EF-ADB2E83653D1}" dt="2023-03-14T00:24:21.392" v="1199" actId="2696"/>
        <pc:sldMkLst>
          <pc:docMk/>
          <pc:sldMk cId="525244294" sldId="717"/>
        </pc:sldMkLst>
        <pc:picChg chg="add del mod modCrop">
          <ac:chgData name="健" userId="845497175cb2f617" providerId="LiveId" clId="{248CE05B-4D93-443E-B6EF-ADB2E83653D1}" dt="2023-03-13T23:56:32.154" v="1039" actId="478"/>
          <ac:picMkLst>
            <pc:docMk/>
            <pc:sldMk cId="525244294" sldId="717"/>
            <ac:picMk id="2" creationId="{FDE502C8-7C37-B3BA-89BB-DB123DC1C8BE}"/>
          </ac:picMkLst>
        </pc:picChg>
        <pc:picChg chg="del mod modCrop">
          <ac:chgData name="健" userId="845497175cb2f617" providerId="LiveId" clId="{248CE05B-4D93-443E-B6EF-ADB2E83653D1}" dt="2023-03-13T23:56:33.478" v="1040" actId="478"/>
          <ac:picMkLst>
            <pc:docMk/>
            <pc:sldMk cId="525244294" sldId="717"/>
            <ac:picMk id="4" creationId="{6CF5FE97-D0E2-7CB3-FFB3-B153372C109A}"/>
          </ac:picMkLst>
        </pc:picChg>
        <pc:picChg chg="add mod">
          <ac:chgData name="健" userId="845497175cb2f617" providerId="LiveId" clId="{248CE05B-4D93-443E-B6EF-ADB2E83653D1}" dt="2023-03-13T23:59:42.705" v="1078" actId="1076"/>
          <ac:picMkLst>
            <pc:docMk/>
            <pc:sldMk cId="525244294" sldId="717"/>
            <ac:picMk id="5" creationId="{E8BDB5FE-EDE2-22B5-0B18-FEB824F82DC9}"/>
          </ac:picMkLst>
        </pc:picChg>
        <pc:picChg chg="add del mod modCrop">
          <ac:chgData name="健" userId="845497175cb2f617" providerId="LiveId" clId="{248CE05B-4D93-443E-B6EF-ADB2E83653D1}" dt="2023-03-13T23:56:29.842" v="1037" actId="478"/>
          <ac:picMkLst>
            <pc:docMk/>
            <pc:sldMk cId="525244294" sldId="717"/>
            <ac:picMk id="6" creationId="{0E98E31B-4200-FA1E-2ACE-94183B937D25}"/>
          </ac:picMkLst>
        </pc:picChg>
        <pc:picChg chg="add del mod modCrop">
          <ac:chgData name="健" userId="845497175cb2f617" providerId="LiveId" clId="{248CE05B-4D93-443E-B6EF-ADB2E83653D1}" dt="2023-03-13T23:56:23.629" v="1031" actId="478"/>
          <ac:picMkLst>
            <pc:docMk/>
            <pc:sldMk cId="525244294" sldId="717"/>
            <ac:picMk id="7" creationId="{9915B834-181A-D5F0-20D3-94A268616715}"/>
          </ac:picMkLst>
        </pc:picChg>
        <pc:picChg chg="add del mod modCrop">
          <ac:chgData name="健" userId="845497175cb2f617" providerId="LiveId" clId="{248CE05B-4D93-443E-B6EF-ADB2E83653D1}" dt="2023-03-13T23:56:22.782" v="1030" actId="478"/>
          <ac:picMkLst>
            <pc:docMk/>
            <pc:sldMk cId="525244294" sldId="717"/>
            <ac:picMk id="8" creationId="{D0058BCD-6AEE-8187-F36D-40A130FE41DA}"/>
          </ac:picMkLst>
        </pc:picChg>
        <pc:picChg chg="add del mod modCrop">
          <ac:chgData name="健" userId="845497175cb2f617" providerId="LiveId" clId="{248CE05B-4D93-443E-B6EF-ADB2E83653D1}" dt="2023-03-13T23:56:24.643" v="1032" actId="478"/>
          <ac:picMkLst>
            <pc:docMk/>
            <pc:sldMk cId="525244294" sldId="717"/>
            <ac:picMk id="9" creationId="{1CABE55A-3CB2-F9DB-BAAD-FB174F733FAF}"/>
          </ac:picMkLst>
        </pc:picChg>
        <pc:picChg chg="add del mod modCrop">
          <ac:chgData name="健" userId="845497175cb2f617" providerId="LiveId" clId="{248CE05B-4D93-443E-B6EF-ADB2E83653D1}" dt="2023-03-13T23:56:36.346" v="1042" actId="478"/>
          <ac:picMkLst>
            <pc:docMk/>
            <pc:sldMk cId="525244294" sldId="717"/>
            <ac:picMk id="10" creationId="{A00EE368-E6D8-F2C8-8203-D55DF3EC879F}"/>
          </ac:picMkLst>
        </pc:picChg>
        <pc:picChg chg="add del mod modCrop">
          <ac:chgData name="健" userId="845497175cb2f617" providerId="LiveId" clId="{248CE05B-4D93-443E-B6EF-ADB2E83653D1}" dt="2023-03-13T23:56:27.809" v="1035" actId="478"/>
          <ac:picMkLst>
            <pc:docMk/>
            <pc:sldMk cId="525244294" sldId="717"/>
            <ac:picMk id="11" creationId="{A91852B9-6291-6392-A798-1B7A611A62A3}"/>
          </ac:picMkLst>
        </pc:picChg>
        <pc:picChg chg="add del mod modCrop">
          <ac:chgData name="健" userId="845497175cb2f617" providerId="LiveId" clId="{248CE05B-4D93-443E-B6EF-ADB2E83653D1}" dt="2023-03-13T23:56:25.985" v="1034" actId="478"/>
          <ac:picMkLst>
            <pc:docMk/>
            <pc:sldMk cId="525244294" sldId="717"/>
            <ac:picMk id="12" creationId="{7AED0E3E-0561-1634-4ABF-8029D84DAAAB}"/>
          </ac:picMkLst>
        </pc:picChg>
        <pc:picChg chg="add del mod modCrop">
          <ac:chgData name="健" userId="845497175cb2f617" providerId="LiveId" clId="{248CE05B-4D93-443E-B6EF-ADB2E83653D1}" dt="2023-03-13T23:56:25.533" v="1033" actId="478"/>
          <ac:picMkLst>
            <pc:docMk/>
            <pc:sldMk cId="525244294" sldId="717"/>
            <ac:picMk id="13" creationId="{1C2A20CC-C709-3FE1-0477-B26D7D237181}"/>
          </ac:picMkLst>
        </pc:picChg>
        <pc:extLst>
          <p:ext xmlns:p="http://schemas.openxmlformats.org/presentationml/2006/main" uri="{D6D511B9-2390-475A-947B-AFAB55BFBCF1}">
            <pc226:cmChg xmlns:pc226="http://schemas.microsoft.com/office/powerpoint/2022/06/main/command" chg="del">
              <pc226:chgData name="健" userId="845497175cb2f617" providerId="LiveId" clId="{248CE05B-4D93-443E-B6EF-ADB2E83653D1}" dt="2023-01-24T23:55:52.587" v="1"/>
              <pc2:cmMkLst xmlns:pc2="http://schemas.microsoft.com/office/powerpoint/2019/9/main/command">
                <pc:docMk/>
                <pc:sldMk cId="525244294" sldId="717"/>
                <pc2:cmMk id="{28045644-D3BB-4C8C-8815-79545B40F5A3}"/>
              </pc2:cmMkLst>
            </pc226:cmChg>
            <pc226:cmChg xmlns:pc226="http://schemas.microsoft.com/office/powerpoint/2022/06/main/command" chg="del">
              <pc226:chgData name="健" userId="845497175cb2f617" providerId="LiveId" clId="{248CE05B-4D93-443E-B6EF-ADB2E83653D1}" dt="2023-01-24T23:55:43.712" v="0"/>
              <pc2:cmMkLst xmlns:pc2="http://schemas.microsoft.com/office/powerpoint/2019/9/main/command">
                <pc:docMk/>
                <pc:sldMk cId="525244294" sldId="717"/>
                <pc2:cmMk id="{B4A5187A-D13D-4013-BF5C-2666D72F4DEE}"/>
              </pc2:cmMkLst>
            </pc226:cmChg>
            <pc226:cmChg xmlns:pc226="http://schemas.microsoft.com/office/powerpoint/2022/06/main/command" chg="del">
              <pc226:chgData name="健" userId="845497175cb2f617" providerId="LiveId" clId="{248CE05B-4D93-443E-B6EF-ADB2E83653D1}" dt="2023-01-24T23:56:03.296" v="2"/>
              <pc2:cmMkLst xmlns:pc2="http://schemas.microsoft.com/office/powerpoint/2019/9/main/command">
                <pc:docMk/>
                <pc:sldMk cId="525244294" sldId="717"/>
                <pc2:cmMk id="{FF242DF4-01AF-4AB2-A89E-EC5131D4DB85}"/>
              </pc2:cmMkLst>
            </pc226:cmChg>
          </p:ext>
        </pc:extLst>
      </pc:sldChg>
      <pc:sldChg chg="delSp modSp mod ord delCm">
        <pc:chgData name="健" userId="845497175cb2f617" providerId="LiveId" clId="{248CE05B-4D93-443E-B6EF-ADB2E83653D1}" dt="2023-03-03T23:33:35.190" v="947" actId="21"/>
        <pc:sldMkLst>
          <pc:docMk/>
          <pc:sldMk cId="2787273873" sldId="732"/>
        </pc:sldMkLst>
        <pc:spChg chg="del">
          <ac:chgData name="健" userId="845497175cb2f617" providerId="LiveId" clId="{248CE05B-4D93-443E-B6EF-ADB2E83653D1}" dt="2023-03-03T23:33:35.190" v="947" actId="21"/>
          <ac:spMkLst>
            <pc:docMk/>
            <pc:sldMk cId="2787273873" sldId="732"/>
            <ac:spMk id="6" creationId="{62A10D26-D5DD-31DF-0722-B21717EB6252}"/>
          </ac:spMkLst>
        </pc:spChg>
        <pc:spChg chg="mod">
          <ac:chgData name="健" userId="845497175cb2f617" providerId="LiveId" clId="{248CE05B-4D93-443E-B6EF-ADB2E83653D1}" dt="2023-03-03T23:33:18.271" v="944" actId="20577"/>
          <ac:spMkLst>
            <pc:docMk/>
            <pc:sldMk cId="2787273873" sldId="732"/>
            <ac:spMk id="10" creationId="{E8920F3F-94E7-39A4-FF20-0415E7A0BBF0}"/>
          </ac:spMkLst>
        </pc:spChg>
        <pc:spChg chg="mod">
          <ac:chgData name="健" userId="845497175cb2f617" providerId="LiveId" clId="{248CE05B-4D93-443E-B6EF-ADB2E83653D1}" dt="2023-03-03T08:34:07.412" v="913" actId="114"/>
          <ac:spMkLst>
            <pc:docMk/>
            <pc:sldMk cId="2787273873" sldId="732"/>
            <ac:spMk id="17" creationId="{A8AA9711-8DC2-11AF-ACEA-FBCE8696DAB4}"/>
          </ac:spMkLst>
        </pc:spChg>
        <pc:spChg chg="mod">
          <ac:chgData name="健" userId="845497175cb2f617" providerId="LiveId" clId="{248CE05B-4D93-443E-B6EF-ADB2E83653D1}" dt="2023-03-03T08:34:19.117" v="916" actId="114"/>
          <ac:spMkLst>
            <pc:docMk/>
            <pc:sldMk cId="2787273873" sldId="732"/>
            <ac:spMk id="18" creationId="{CC5D9E07-E9CF-9393-E1B9-25AED742D5E0}"/>
          </ac:spMkLst>
        </pc:spChg>
        <pc:cxnChg chg="del">
          <ac:chgData name="健" userId="845497175cb2f617" providerId="LiveId" clId="{248CE05B-4D93-443E-B6EF-ADB2E83653D1}" dt="2023-02-07T08:08:20.556" v="9" actId="478"/>
          <ac:cxnSpMkLst>
            <pc:docMk/>
            <pc:sldMk cId="2787273873" sldId="732"/>
            <ac:cxnSpMk id="4" creationId="{A8F39536-814D-8788-F15A-DA04CDCF30B9}"/>
          </ac:cxnSpMkLst>
        </pc:cxnChg>
        <pc:extLst>
          <p:ext xmlns:p="http://schemas.openxmlformats.org/presentationml/2006/main" uri="{D6D511B9-2390-475A-947B-AFAB55BFBCF1}">
            <pc226:cmChg xmlns:pc226="http://schemas.microsoft.com/office/powerpoint/2022/06/main/command" chg="del">
              <pc226:chgData name="健" userId="845497175cb2f617" providerId="LiveId" clId="{248CE05B-4D93-443E-B6EF-ADB2E83653D1}" dt="2023-01-24T23:57:27.679" v="7"/>
              <pc2:cmMkLst xmlns:pc2="http://schemas.microsoft.com/office/powerpoint/2019/9/main/command">
                <pc:docMk/>
                <pc:sldMk cId="2787273873" sldId="732"/>
                <pc2:cmMk id="{E45B0616-B924-41BA-8F1B-B94ECADA075B}"/>
              </pc2:cmMkLst>
            </pc226:cmChg>
            <pc226:cmChg xmlns:pc226="http://schemas.microsoft.com/office/powerpoint/2022/06/main/command" chg="del">
              <pc226:chgData name="健" userId="845497175cb2f617" providerId="LiveId" clId="{248CE05B-4D93-443E-B6EF-ADB2E83653D1}" dt="2023-01-24T23:57:30.758" v="8"/>
              <pc2:cmMkLst xmlns:pc2="http://schemas.microsoft.com/office/powerpoint/2019/9/main/command">
                <pc:docMk/>
                <pc:sldMk cId="2787273873" sldId="732"/>
                <pc2:cmMk id="{4606F9C0-22F8-43E9-AFFB-DCA90F328A63}"/>
              </pc2:cmMkLst>
            </pc226:cmChg>
          </p:ext>
        </pc:extLst>
      </pc:sldChg>
      <pc:sldChg chg="addSp delSp modSp new mod ord">
        <pc:chgData name="健" userId="845497175cb2f617" providerId="LiveId" clId="{248CE05B-4D93-443E-B6EF-ADB2E83653D1}" dt="2023-03-03T23:33:23.875" v="946" actId="20577"/>
        <pc:sldMkLst>
          <pc:docMk/>
          <pc:sldMk cId="2896534360" sldId="733"/>
        </pc:sldMkLst>
        <pc:spChg chg="del">
          <ac:chgData name="健" userId="845497175cb2f617" providerId="LiveId" clId="{248CE05B-4D93-443E-B6EF-ADB2E83653D1}" dt="2023-02-15T07:29:10.155" v="11" actId="478"/>
          <ac:spMkLst>
            <pc:docMk/>
            <pc:sldMk cId="2896534360" sldId="733"/>
            <ac:spMk id="2" creationId="{D56FE790-156E-CB76-76BA-65D70B682E3E}"/>
          </ac:spMkLst>
        </pc:spChg>
        <pc:spChg chg="del">
          <ac:chgData name="健" userId="845497175cb2f617" providerId="LiveId" clId="{248CE05B-4D93-443E-B6EF-ADB2E83653D1}" dt="2023-02-15T07:29:11.557" v="12" actId="478"/>
          <ac:spMkLst>
            <pc:docMk/>
            <pc:sldMk cId="2896534360" sldId="733"/>
            <ac:spMk id="3" creationId="{8C9C8106-50AA-A053-AEB8-545F192833A7}"/>
          </ac:spMkLst>
        </pc:spChg>
        <pc:spChg chg="add mod">
          <ac:chgData name="健" userId="845497175cb2f617" providerId="LiveId" clId="{248CE05B-4D93-443E-B6EF-ADB2E83653D1}" dt="2023-03-03T23:33:23.875" v="946" actId="20577"/>
          <ac:spMkLst>
            <pc:docMk/>
            <pc:sldMk cId="2896534360" sldId="733"/>
            <ac:spMk id="7" creationId="{054B640E-A07D-6DAC-0BFA-7373B4B5D28A}"/>
          </ac:spMkLst>
        </pc:spChg>
        <pc:spChg chg="add mod">
          <ac:chgData name="健" userId="845497175cb2f617" providerId="LiveId" clId="{248CE05B-4D93-443E-B6EF-ADB2E83653D1}" dt="2023-02-15T07:59:40.904" v="93" actId="1076"/>
          <ac:spMkLst>
            <pc:docMk/>
            <pc:sldMk cId="2896534360" sldId="733"/>
            <ac:spMk id="8" creationId="{78A62B88-9864-EA06-1C40-51D8F5349C79}"/>
          </ac:spMkLst>
        </pc:spChg>
        <pc:spChg chg="add del mod">
          <ac:chgData name="健" userId="845497175cb2f617" providerId="LiveId" clId="{248CE05B-4D93-443E-B6EF-ADB2E83653D1}" dt="2023-02-15T07:48:03.914" v="55" actId="478"/>
          <ac:spMkLst>
            <pc:docMk/>
            <pc:sldMk cId="2896534360" sldId="733"/>
            <ac:spMk id="9" creationId="{5BAF372D-8ED4-7B6C-878E-67A4B94105DD}"/>
          </ac:spMkLst>
        </pc:spChg>
        <pc:spChg chg="add del mod">
          <ac:chgData name="健" userId="845497175cb2f617" providerId="LiveId" clId="{248CE05B-4D93-443E-B6EF-ADB2E83653D1}" dt="2023-02-15T07:48:29.801" v="61" actId="478"/>
          <ac:spMkLst>
            <pc:docMk/>
            <pc:sldMk cId="2896534360" sldId="733"/>
            <ac:spMk id="10" creationId="{5C4567BF-18B1-B756-735E-C5044E18FA10}"/>
          </ac:spMkLst>
        </pc:spChg>
        <pc:spChg chg="add mod">
          <ac:chgData name="健" userId="845497175cb2f617" providerId="LiveId" clId="{248CE05B-4D93-443E-B6EF-ADB2E83653D1}" dt="2023-02-15T07:59:40.904" v="93" actId="1076"/>
          <ac:spMkLst>
            <pc:docMk/>
            <pc:sldMk cId="2896534360" sldId="733"/>
            <ac:spMk id="11" creationId="{6325CC48-4485-B957-E07B-D102A19EE96D}"/>
          </ac:spMkLst>
        </pc:spChg>
        <pc:spChg chg="add mod">
          <ac:chgData name="健" userId="845497175cb2f617" providerId="LiveId" clId="{248CE05B-4D93-443E-B6EF-ADB2E83653D1}" dt="2023-02-15T07:59:40.904" v="93" actId="1076"/>
          <ac:spMkLst>
            <pc:docMk/>
            <pc:sldMk cId="2896534360" sldId="733"/>
            <ac:spMk id="12" creationId="{B9966725-7678-E3FF-5C5A-07FDE6523D98}"/>
          </ac:spMkLst>
        </pc:spChg>
        <pc:graphicFrameChg chg="add mod">
          <ac:chgData name="健" userId="845497175cb2f617" providerId="LiveId" clId="{248CE05B-4D93-443E-B6EF-ADB2E83653D1}" dt="2023-02-15T07:59:40.904" v="93" actId="1076"/>
          <ac:graphicFrameMkLst>
            <pc:docMk/>
            <pc:sldMk cId="2896534360" sldId="733"/>
            <ac:graphicFrameMk id="4" creationId="{2EFC138D-CF68-12FB-9309-3918B1545C5B}"/>
          </ac:graphicFrameMkLst>
        </pc:graphicFrameChg>
        <pc:graphicFrameChg chg="add del mod">
          <ac:chgData name="健" userId="845497175cb2f617" providerId="LiveId" clId="{248CE05B-4D93-443E-B6EF-ADB2E83653D1}" dt="2023-02-15T07:59:40.904" v="93" actId="1076"/>
          <ac:graphicFrameMkLst>
            <pc:docMk/>
            <pc:sldMk cId="2896534360" sldId="733"/>
            <ac:graphicFrameMk id="5" creationId="{61C3DB40-6AAF-A612-B2D2-F28D73F2E77A}"/>
          </ac:graphicFrameMkLst>
        </pc:graphicFrameChg>
        <pc:graphicFrameChg chg="add mod">
          <ac:chgData name="健" userId="845497175cb2f617" providerId="LiveId" clId="{248CE05B-4D93-443E-B6EF-ADB2E83653D1}" dt="2023-02-15T07:59:40.904" v="93" actId="1076"/>
          <ac:graphicFrameMkLst>
            <pc:docMk/>
            <pc:sldMk cId="2896534360" sldId="733"/>
            <ac:graphicFrameMk id="6" creationId="{E64B226D-0183-394B-35EF-DDF6940E20F8}"/>
          </ac:graphicFrameMkLst>
        </pc:graphicFrameChg>
      </pc:sldChg>
      <pc:sldChg chg="addSp delSp modSp new del mod">
        <pc:chgData name="健" userId="845497175cb2f617" providerId="LiveId" clId="{248CE05B-4D93-443E-B6EF-ADB2E83653D1}" dt="2023-03-03T05:26:04.689" v="910" actId="2696"/>
        <pc:sldMkLst>
          <pc:docMk/>
          <pc:sldMk cId="2999829055" sldId="734"/>
        </pc:sldMkLst>
        <pc:spChg chg="del">
          <ac:chgData name="健" userId="845497175cb2f617" providerId="LiveId" clId="{248CE05B-4D93-443E-B6EF-ADB2E83653D1}" dt="2023-02-20T08:09:02.551" v="102" actId="478"/>
          <ac:spMkLst>
            <pc:docMk/>
            <pc:sldMk cId="2999829055" sldId="734"/>
            <ac:spMk id="2" creationId="{506C45E2-B713-1668-6786-C624B3F59FE5}"/>
          </ac:spMkLst>
        </pc:spChg>
        <pc:spChg chg="del">
          <ac:chgData name="健" userId="845497175cb2f617" providerId="LiveId" clId="{248CE05B-4D93-443E-B6EF-ADB2E83653D1}" dt="2023-02-20T08:09:03.591" v="103" actId="478"/>
          <ac:spMkLst>
            <pc:docMk/>
            <pc:sldMk cId="2999829055" sldId="734"/>
            <ac:spMk id="3" creationId="{803EB65F-8141-BA8E-E79C-2E798FB022C0}"/>
          </ac:spMkLst>
        </pc:spChg>
        <pc:spChg chg="add mod">
          <ac:chgData name="健" userId="845497175cb2f617" providerId="LiveId" clId="{248CE05B-4D93-443E-B6EF-ADB2E83653D1}" dt="2023-02-20T08:15:15.918" v="154" actId="20577"/>
          <ac:spMkLst>
            <pc:docMk/>
            <pc:sldMk cId="2999829055" sldId="734"/>
            <ac:spMk id="4" creationId="{A12B4970-CF36-AA6C-5CE1-AB0D12DC97C6}"/>
          </ac:spMkLst>
        </pc:spChg>
      </pc:sldChg>
      <pc:sldChg chg="addSp delSp modSp new mod">
        <pc:chgData name="健" userId="845497175cb2f617" providerId="LiveId" clId="{248CE05B-4D93-443E-B6EF-ADB2E83653D1}" dt="2023-03-03T23:33:45.802" v="949" actId="1076"/>
        <pc:sldMkLst>
          <pc:docMk/>
          <pc:sldMk cId="3904400895" sldId="735"/>
        </pc:sldMkLst>
        <pc:spChg chg="del">
          <ac:chgData name="健" userId="845497175cb2f617" providerId="LiveId" clId="{248CE05B-4D93-443E-B6EF-ADB2E83653D1}" dt="2023-03-02T23:25:45.980" v="156" actId="478"/>
          <ac:spMkLst>
            <pc:docMk/>
            <pc:sldMk cId="3904400895" sldId="735"/>
            <ac:spMk id="2" creationId="{0A38E27E-E9D4-3C17-BB68-D8D9F87D0EE0}"/>
          </ac:spMkLst>
        </pc:spChg>
        <pc:spChg chg="del">
          <ac:chgData name="健" userId="845497175cb2f617" providerId="LiveId" clId="{248CE05B-4D93-443E-B6EF-ADB2E83653D1}" dt="2023-03-02T23:25:48.705" v="157" actId="478"/>
          <ac:spMkLst>
            <pc:docMk/>
            <pc:sldMk cId="3904400895" sldId="735"/>
            <ac:spMk id="3" creationId="{104EDF8E-4DD3-215F-8E27-373D8C27EDE3}"/>
          </ac:spMkLst>
        </pc:spChg>
        <pc:spChg chg="add mod">
          <ac:chgData name="健" userId="845497175cb2f617" providerId="LiveId" clId="{248CE05B-4D93-443E-B6EF-ADB2E83653D1}" dt="2023-03-03T04:06:03.826" v="270" actId="1076"/>
          <ac:spMkLst>
            <pc:docMk/>
            <pc:sldMk cId="3904400895" sldId="735"/>
            <ac:spMk id="7" creationId="{601C477B-84CE-D566-B2FA-46423B53974A}"/>
          </ac:spMkLst>
        </pc:spChg>
        <pc:spChg chg="add mod">
          <ac:chgData name="健" userId="845497175cb2f617" providerId="LiveId" clId="{248CE05B-4D93-443E-B6EF-ADB2E83653D1}" dt="2023-03-03T23:33:04.631" v="940" actId="20577"/>
          <ac:spMkLst>
            <pc:docMk/>
            <pc:sldMk cId="3904400895" sldId="735"/>
            <ac:spMk id="9" creationId="{7B8A0CAC-8258-C374-A9AC-A3D3D44B99BB}"/>
          </ac:spMkLst>
        </pc:spChg>
        <pc:spChg chg="add del mod">
          <ac:chgData name="健" userId="845497175cb2f617" providerId="LiveId" clId="{248CE05B-4D93-443E-B6EF-ADB2E83653D1}" dt="2023-03-03T05:20:52.832" v="849" actId="478"/>
          <ac:spMkLst>
            <pc:docMk/>
            <pc:sldMk cId="3904400895" sldId="735"/>
            <ac:spMk id="14" creationId="{55D03F5A-F385-5406-1950-C8E3E8BC652D}"/>
          </ac:spMkLst>
        </pc:spChg>
        <pc:spChg chg="add mod">
          <ac:chgData name="健" userId="845497175cb2f617" providerId="LiveId" clId="{248CE05B-4D93-443E-B6EF-ADB2E83653D1}" dt="2023-03-03T04:54:23.959" v="593" actId="1076"/>
          <ac:spMkLst>
            <pc:docMk/>
            <pc:sldMk cId="3904400895" sldId="735"/>
            <ac:spMk id="17" creationId="{ED4D6A0F-A86E-A2C9-C26D-D91C97C8270E}"/>
          </ac:spMkLst>
        </pc:spChg>
        <pc:spChg chg="add del">
          <ac:chgData name="健" userId="845497175cb2f617" providerId="LiveId" clId="{248CE05B-4D93-443E-B6EF-ADB2E83653D1}" dt="2023-03-03T05:20:45.579" v="846" actId="22"/>
          <ac:spMkLst>
            <pc:docMk/>
            <pc:sldMk cId="3904400895" sldId="735"/>
            <ac:spMk id="20" creationId="{C2638C61-2FF6-1E86-E513-8BA32D10FB24}"/>
          </ac:spMkLst>
        </pc:spChg>
        <pc:spChg chg="add mod">
          <ac:chgData name="健" userId="845497175cb2f617" providerId="LiveId" clId="{248CE05B-4D93-443E-B6EF-ADB2E83653D1}" dt="2023-03-03T05:21:07.305" v="852" actId="1076"/>
          <ac:spMkLst>
            <pc:docMk/>
            <pc:sldMk cId="3904400895" sldId="735"/>
            <ac:spMk id="22" creationId="{AEDF93C0-DFAB-B3CF-03E8-F7D50C08EF19}"/>
          </ac:spMkLst>
        </pc:spChg>
        <pc:spChg chg="add del">
          <ac:chgData name="健" userId="845497175cb2f617" providerId="LiveId" clId="{248CE05B-4D93-443E-B6EF-ADB2E83653D1}" dt="2023-03-03T05:21:11.900" v="854" actId="22"/>
          <ac:spMkLst>
            <pc:docMk/>
            <pc:sldMk cId="3904400895" sldId="735"/>
            <ac:spMk id="24" creationId="{6D90A8F1-CAD8-D540-791A-4FCC54EA2BB4}"/>
          </ac:spMkLst>
        </pc:spChg>
        <pc:spChg chg="add mod">
          <ac:chgData name="健" userId="845497175cb2f617" providerId="LiveId" clId="{248CE05B-4D93-443E-B6EF-ADB2E83653D1}" dt="2023-03-03T05:21:24.042" v="857" actId="1076"/>
          <ac:spMkLst>
            <pc:docMk/>
            <pc:sldMk cId="3904400895" sldId="735"/>
            <ac:spMk id="26" creationId="{50C26033-9B58-DA0F-4246-42D5AC75E4C4}"/>
          </ac:spMkLst>
        </pc:spChg>
        <pc:spChg chg="add mod">
          <ac:chgData name="健" userId="845497175cb2f617" providerId="LiveId" clId="{248CE05B-4D93-443E-B6EF-ADB2E83653D1}" dt="2023-03-03T23:33:45.802" v="949" actId="1076"/>
          <ac:spMkLst>
            <pc:docMk/>
            <pc:sldMk cId="3904400895" sldId="735"/>
            <ac:spMk id="27" creationId="{DB351C67-CC90-E146-9CCF-0E462D9A3AAE}"/>
          </ac:spMkLst>
        </pc:spChg>
        <pc:graphicFrameChg chg="add del mod">
          <ac:chgData name="健" userId="845497175cb2f617" providerId="LiveId" clId="{248CE05B-4D93-443E-B6EF-ADB2E83653D1}" dt="2023-03-02T23:58:45.676" v="217" actId="478"/>
          <ac:graphicFrameMkLst>
            <pc:docMk/>
            <pc:sldMk cId="3904400895" sldId="735"/>
            <ac:graphicFrameMk id="11" creationId="{B5B51FD4-6A8C-D568-8D69-B2F8825D6307}"/>
          </ac:graphicFrameMkLst>
        </pc:graphicFrameChg>
        <pc:picChg chg="add mod">
          <ac:chgData name="健" userId="845497175cb2f617" providerId="LiveId" clId="{248CE05B-4D93-443E-B6EF-ADB2E83653D1}" dt="2023-03-03T04:06:03.826" v="270" actId="1076"/>
          <ac:picMkLst>
            <pc:docMk/>
            <pc:sldMk cId="3904400895" sldId="735"/>
            <ac:picMk id="5" creationId="{8FDE8E5F-9ECD-8685-6EE6-02C8AD217CE1}"/>
          </ac:picMkLst>
        </pc:picChg>
        <pc:picChg chg="add del mod">
          <ac:chgData name="健" userId="845497175cb2f617" providerId="LiveId" clId="{248CE05B-4D93-443E-B6EF-ADB2E83653D1}" dt="2023-03-02T23:56:35.548" v="212" actId="478"/>
          <ac:picMkLst>
            <pc:docMk/>
            <pc:sldMk cId="3904400895" sldId="735"/>
            <ac:picMk id="10" creationId="{32A88785-5A27-C5D4-60FC-B20A6E798EB3}"/>
          </ac:picMkLst>
        </pc:picChg>
        <pc:picChg chg="add mod">
          <ac:chgData name="健" userId="845497175cb2f617" providerId="LiveId" clId="{248CE05B-4D93-443E-B6EF-ADB2E83653D1}" dt="2023-03-03T04:06:03.826" v="270" actId="1076"/>
          <ac:picMkLst>
            <pc:docMk/>
            <pc:sldMk cId="3904400895" sldId="735"/>
            <ac:picMk id="13" creationId="{3F56F953-BA9D-3A78-E379-1A7F72171972}"/>
          </ac:picMkLst>
        </pc:picChg>
        <pc:picChg chg="add mod">
          <ac:chgData name="健" userId="845497175cb2f617" providerId="LiveId" clId="{248CE05B-4D93-443E-B6EF-ADB2E83653D1}" dt="2023-03-03T04:54:16.735" v="592" actId="1076"/>
          <ac:picMkLst>
            <pc:docMk/>
            <pc:sldMk cId="3904400895" sldId="735"/>
            <ac:picMk id="16" creationId="{E577DCBF-E016-5DE7-5D96-E029F8F624FB}"/>
          </ac:picMkLst>
        </pc:picChg>
        <pc:picChg chg="add mod">
          <ac:chgData name="健" userId="845497175cb2f617" providerId="LiveId" clId="{248CE05B-4D93-443E-B6EF-ADB2E83653D1}" dt="2023-03-03T04:53:45.488" v="579" actId="1076"/>
          <ac:picMkLst>
            <pc:docMk/>
            <pc:sldMk cId="3904400895" sldId="735"/>
            <ac:picMk id="18" creationId="{52527CAE-4723-6783-D997-BF7C3A603920}"/>
          </ac:picMkLst>
        </pc:picChg>
      </pc:sldChg>
      <pc:sldChg chg="addSp modSp mod">
        <pc:chgData name="健" userId="845497175cb2f617" providerId="LiveId" clId="{248CE05B-4D93-443E-B6EF-ADB2E83653D1}" dt="2023-03-03T05:21:42.260" v="859" actId="1076"/>
        <pc:sldMkLst>
          <pc:docMk/>
          <pc:sldMk cId="1221763323" sldId="736"/>
        </pc:sldMkLst>
        <pc:spChg chg="add mod">
          <ac:chgData name="健" userId="845497175cb2f617" providerId="LiveId" clId="{248CE05B-4D93-443E-B6EF-ADB2E83653D1}" dt="2023-03-03T05:21:37.641" v="858" actId="1076"/>
          <ac:spMkLst>
            <pc:docMk/>
            <pc:sldMk cId="1221763323" sldId="736"/>
            <ac:spMk id="4" creationId="{7E4047CC-1DEA-05FF-55DA-B08F4FB100C4}"/>
          </ac:spMkLst>
        </pc:spChg>
        <pc:spChg chg="add mod">
          <ac:chgData name="健" userId="845497175cb2f617" providerId="LiveId" clId="{248CE05B-4D93-443E-B6EF-ADB2E83653D1}" dt="2023-03-03T05:21:42.260" v="859" actId="1076"/>
          <ac:spMkLst>
            <pc:docMk/>
            <pc:sldMk cId="1221763323" sldId="736"/>
            <ac:spMk id="7" creationId="{2BDBD658-EB31-917F-247D-5D4427FC69D9}"/>
          </ac:spMkLst>
        </pc:spChg>
        <pc:spChg chg="add mod">
          <ac:chgData name="健" userId="845497175cb2f617" providerId="LiveId" clId="{248CE05B-4D93-443E-B6EF-ADB2E83653D1}" dt="2023-03-03T04:55:50.325" v="613" actId="20577"/>
          <ac:spMkLst>
            <pc:docMk/>
            <pc:sldMk cId="1221763323" sldId="736"/>
            <ac:spMk id="8" creationId="{02B88BFA-4181-85C7-B9A2-29490E69A4BC}"/>
          </ac:spMkLst>
        </pc:spChg>
        <pc:spChg chg="add mod">
          <ac:chgData name="健" userId="845497175cb2f617" providerId="LiveId" clId="{248CE05B-4D93-443E-B6EF-ADB2E83653D1}" dt="2023-03-03T04:55:06.807" v="604" actId="20577"/>
          <ac:spMkLst>
            <pc:docMk/>
            <pc:sldMk cId="1221763323" sldId="736"/>
            <ac:spMk id="10" creationId="{C2F54CCD-C11F-8CA5-19C3-9D2731CB8B28}"/>
          </ac:spMkLst>
        </pc:spChg>
        <pc:picChg chg="add mod">
          <ac:chgData name="健" userId="845497175cb2f617" providerId="LiveId" clId="{248CE05B-4D93-443E-B6EF-ADB2E83653D1}" dt="2023-03-03T04:08:04.502" v="273" actId="1076"/>
          <ac:picMkLst>
            <pc:docMk/>
            <pc:sldMk cId="1221763323" sldId="736"/>
            <ac:picMk id="3" creationId="{25F37EBE-5ED6-063E-977E-6D27018481D4}"/>
          </ac:picMkLst>
        </pc:picChg>
        <pc:picChg chg="add mod">
          <ac:chgData name="健" userId="845497175cb2f617" providerId="LiveId" clId="{248CE05B-4D93-443E-B6EF-ADB2E83653D1}" dt="2023-03-03T04:10:30.471" v="297" actId="1076"/>
          <ac:picMkLst>
            <pc:docMk/>
            <pc:sldMk cId="1221763323" sldId="736"/>
            <ac:picMk id="6" creationId="{1FA522A2-D0CF-9CBF-1908-C59C3752B6B8}"/>
          </ac:picMkLst>
        </pc:picChg>
        <pc:picChg chg="add mod">
          <ac:chgData name="健" userId="845497175cb2f617" providerId="LiveId" clId="{248CE05B-4D93-443E-B6EF-ADB2E83653D1}" dt="2023-03-03T04:55:29.691" v="605" actId="1076"/>
          <ac:picMkLst>
            <pc:docMk/>
            <pc:sldMk cId="1221763323" sldId="736"/>
            <ac:picMk id="9" creationId="{4CFD2089-E530-1A68-38F8-11E0F9E7D18C}"/>
          </ac:picMkLst>
        </pc:picChg>
        <pc:picChg chg="add mod">
          <ac:chgData name="健" userId="845497175cb2f617" providerId="LiveId" clId="{248CE05B-4D93-443E-B6EF-ADB2E83653D1}" dt="2023-03-03T04:54:45.440" v="596" actId="1076"/>
          <ac:picMkLst>
            <pc:docMk/>
            <pc:sldMk cId="1221763323" sldId="736"/>
            <ac:picMk id="11" creationId="{4BBD4134-A975-5BF1-8C0E-013252847B4A}"/>
          </ac:picMkLst>
        </pc:picChg>
      </pc:sldChg>
      <pc:sldChg chg="addSp modSp mod">
        <pc:chgData name="健" userId="845497175cb2f617" providerId="LiveId" clId="{248CE05B-4D93-443E-B6EF-ADB2E83653D1}" dt="2023-03-03T05:22:28.023" v="868" actId="1076"/>
        <pc:sldMkLst>
          <pc:docMk/>
          <pc:sldMk cId="341717010" sldId="737"/>
        </pc:sldMkLst>
        <pc:spChg chg="add mod">
          <ac:chgData name="健" userId="845497175cb2f617" providerId="LiveId" clId="{248CE05B-4D93-443E-B6EF-ADB2E83653D1}" dt="2023-03-03T05:22:05.249" v="862" actId="14100"/>
          <ac:spMkLst>
            <pc:docMk/>
            <pc:sldMk cId="341717010" sldId="737"/>
            <ac:spMk id="6" creationId="{B56DFF47-E6E4-9219-336D-3ED616112DDC}"/>
          </ac:spMkLst>
        </pc:spChg>
        <pc:spChg chg="add mod">
          <ac:chgData name="健" userId="845497175cb2f617" providerId="LiveId" clId="{248CE05B-4D93-443E-B6EF-ADB2E83653D1}" dt="2023-03-03T04:58:19.778" v="631" actId="1076"/>
          <ac:spMkLst>
            <pc:docMk/>
            <pc:sldMk cId="341717010" sldId="737"/>
            <ac:spMk id="7" creationId="{5A185D9D-8C7F-EF2B-09F3-3C5AF9409F81}"/>
          </ac:spMkLst>
        </pc:spChg>
        <pc:spChg chg="add mod">
          <ac:chgData name="健" userId="845497175cb2f617" providerId="LiveId" clId="{248CE05B-4D93-443E-B6EF-ADB2E83653D1}" dt="2023-03-03T04:59:16.177" v="644" actId="1076"/>
          <ac:spMkLst>
            <pc:docMk/>
            <pc:sldMk cId="341717010" sldId="737"/>
            <ac:spMk id="9" creationId="{13634289-CD4F-2B40-15F9-9D2CCD9A3908}"/>
          </ac:spMkLst>
        </pc:spChg>
        <pc:spChg chg="add mod">
          <ac:chgData name="健" userId="845497175cb2f617" providerId="LiveId" clId="{248CE05B-4D93-443E-B6EF-ADB2E83653D1}" dt="2023-03-03T05:22:28.023" v="868" actId="1076"/>
          <ac:spMkLst>
            <pc:docMk/>
            <pc:sldMk cId="341717010" sldId="737"/>
            <ac:spMk id="12" creationId="{E021AE95-16EA-EB34-A7C8-B714230C2361}"/>
          </ac:spMkLst>
        </pc:spChg>
        <pc:picChg chg="add mod">
          <ac:chgData name="健" userId="845497175cb2f617" providerId="LiveId" clId="{248CE05B-4D93-443E-B6EF-ADB2E83653D1}" dt="2023-03-03T04:13:55.594" v="313" actId="1076"/>
          <ac:picMkLst>
            <pc:docMk/>
            <pc:sldMk cId="341717010" sldId="737"/>
            <ac:picMk id="3" creationId="{50EA3803-5E40-FDDA-2EF0-B7D6880F5E20}"/>
          </ac:picMkLst>
        </pc:picChg>
        <pc:picChg chg="add mod">
          <ac:chgData name="健" userId="845497175cb2f617" providerId="LiveId" clId="{248CE05B-4D93-443E-B6EF-ADB2E83653D1}" dt="2023-03-03T04:58:03.993" v="629" actId="1076"/>
          <ac:picMkLst>
            <pc:docMk/>
            <pc:sldMk cId="341717010" sldId="737"/>
            <ac:picMk id="5" creationId="{1F1E1164-FCA8-480C-84FB-BAA7D7C1E627}"/>
          </ac:picMkLst>
        </pc:picChg>
        <pc:picChg chg="add mod">
          <ac:chgData name="健" userId="845497175cb2f617" providerId="LiveId" clId="{248CE05B-4D93-443E-B6EF-ADB2E83653D1}" dt="2023-03-03T04:58:13.320" v="630" actId="1076"/>
          <ac:picMkLst>
            <pc:docMk/>
            <pc:sldMk cId="341717010" sldId="737"/>
            <ac:picMk id="8" creationId="{58D6EC1E-685E-C50E-BFB1-7C3009F3FEDD}"/>
          </ac:picMkLst>
        </pc:picChg>
        <pc:picChg chg="add mod">
          <ac:chgData name="健" userId="845497175cb2f617" providerId="LiveId" clId="{248CE05B-4D93-443E-B6EF-ADB2E83653D1}" dt="2023-03-03T04:58:41.640" v="633" actId="1076"/>
          <ac:picMkLst>
            <pc:docMk/>
            <pc:sldMk cId="341717010" sldId="737"/>
            <ac:picMk id="10" creationId="{06FFC932-71BA-0F09-5845-350AD7035446}"/>
          </ac:picMkLst>
        </pc:picChg>
      </pc:sldChg>
      <pc:sldChg chg="addSp modSp mod">
        <pc:chgData name="健" userId="845497175cb2f617" providerId="LiveId" clId="{248CE05B-4D93-443E-B6EF-ADB2E83653D1}" dt="2023-03-03T05:23:09.517" v="876" actId="1076"/>
        <pc:sldMkLst>
          <pc:docMk/>
          <pc:sldMk cId="4086761036" sldId="738"/>
        </pc:sldMkLst>
        <pc:spChg chg="add mod">
          <ac:chgData name="健" userId="845497175cb2f617" providerId="LiveId" clId="{248CE05B-4D93-443E-B6EF-ADB2E83653D1}" dt="2023-03-03T05:22:57.778" v="873" actId="14100"/>
          <ac:spMkLst>
            <pc:docMk/>
            <pc:sldMk cId="4086761036" sldId="738"/>
            <ac:spMk id="4" creationId="{3C4111FB-27EF-B302-A26D-B3859883464D}"/>
          </ac:spMkLst>
        </pc:spChg>
        <pc:spChg chg="add mod">
          <ac:chgData name="健" userId="845497175cb2f617" providerId="LiveId" clId="{248CE05B-4D93-443E-B6EF-ADB2E83653D1}" dt="2023-03-03T05:00:58.156" v="672" actId="1076"/>
          <ac:spMkLst>
            <pc:docMk/>
            <pc:sldMk cId="4086761036" sldId="738"/>
            <ac:spMk id="7" creationId="{5787BABC-27DD-57DD-11AA-17CF1FD733E5}"/>
          </ac:spMkLst>
        </pc:spChg>
        <pc:spChg chg="add mod">
          <ac:chgData name="健" userId="845497175cb2f617" providerId="LiveId" clId="{248CE05B-4D93-443E-B6EF-ADB2E83653D1}" dt="2023-03-03T05:01:45.045" v="682" actId="14100"/>
          <ac:spMkLst>
            <pc:docMk/>
            <pc:sldMk cId="4086761036" sldId="738"/>
            <ac:spMk id="9" creationId="{94D1F4F4-B65D-2A17-9A63-395BDAE25A4F}"/>
          </ac:spMkLst>
        </pc:spChg>
        <pc:spChg chg="add mod">
          <ac:chgData name="健" userId="845497175cb2f617" providerId="LiveId" clId="{248CE05B-4D93-443E-B6EF-ADB2E83653D1}" dt="2023-03-03T05:23:09.517" v="876" actId="1076"/>
          <ac:spMkLst>
            <pc:docMk/>
            <pc:sldMk cId="4086761036" sldId="738"/>
            <ac:spMk id="12" creationId="{4FF54DD8-7F47-2900-EA2D-A4454E1EAC14}"/>
          </ac:spMkLst>
        </pc:spChg>
        <pc:picChg chg="add mod">
          <ac:chgData name="健" userId="845497175cb2f617" providerId="LiveId" clId="{248CE05B-4D93-443E-B6EF-ADB2E83653D1}" dt="2023-03-03T04:34:05.192" v="400" actId="1076"/>
          <ac:picMkLst>
            <pc:docMk/>
            <pc:sldMk cId="4086761036" sldId="738"/>
            <ac:picMk id="3" creationId="{9709E963-521D-C960-CF36-81B72EB329FC}"/>
          </ac:picMkLst>
        </pc:picChg>
        <pc:picChg chg="add mod">
          <ac:chgData name="健" userId="845497175cb2f617" providerId="LiveId" clId="{248CE05B-4D93-443E-B6EF-ADB2E83653D1}" dt="2023-03-03T04:35:45.855" v="427" actId="1076"/>
          <ac:picMkLst>
            <pc:docMk/>
            <pc:sldMk cId="4086761036" sldId="738"/>
            <ac:picMk id="6" creationId="{909D87CE-2C3F-D396-C180-6F5F66723C88}"/>
          </ac:picMkLst>
        </pc:picChg>
        <pc:picChg chg="add mod">
          <ac:chgData name="健" userId="845497175cb2f617" providerId="LiveId" clId="{248CE05B-4D93-443E-B6EF-ADB2E83653D1}" dt="2023-03-03T05:01:02.346" v="673" actId="1076"/>
          <ac:picMkLst>
            <pc:docMk/>
            <pc:sldMk cId="4086761036" sldId="738"/>
            <ac:picMk id="8" creationId="{E236089C-CDB8-7583-059F-012151BB4DF0}"/>
          </ac:picMkLst>
        </pc:picChg>
        <pc:picChg chg="add mod">
          <ac:chgData name="健" userId="845497175cb2f617" providerId="LiveId" clId="{248CE05B-4D93-443E-B6EF-ADB2E83653D1}" dt="2023-03-03T05:01:15.857" v="675" actId="1076"/>
          <ac:picMkLst>
            <pc:docMk/>
            <pc:sldMk cId="4086761036" sldId="738"/>
            <ac:picMk id="10" creationId="{3C4413EE-FF92-3FD4-9368-4586503E56A2}"/>
          </ac:picMkLst>
        </pc:picChg>
      </pc:sldChg>
      <pc:sldChg chg="addSp modSp mod">
        <pc:chgData name="健" userId="845497175cb2f617" providerId="LiveId" clId="{248CE05B-4D93-443E-B6EF-ADB2E83653D1}" dt="2023-03-03T05:22:37.539" v="869" actId="1076"/>
        <pc:sldMkLst>
          <pc:docMk/>
          <pc:sldMk cId="2463354579" sldId="739"/>
        </pc:sldMkLst>
        <pc:spChg chg="add mod">
          <ac:chgData name="健" userId="845497175cb2f617" providerId="LiveId" clId="{248CE05B-4D93-443E-B6EF-ADB2E83653D1}" dt="2023-03-03T05:22:37.539" v="869" actId="1076"/>
          <ac:spMkLst>
            <pc:docMk/>
            <pc:sldMk cId="2463354579" sldId="739"/>
            <ac:spMk id="4" creationId="{2BC2600D-679B-F038-D6FF-C928DC00467C}"/>
          </ac:spMkLst>
        </pc:spChg>
        <pc:spChg chg="add mod">
          <ac:chgData name="健" userId="845497175cb2f617" providerId="LiveId" clId="{248CE05B-4D93-443E-B6EF-ADB2E83653D1}" dt="2023-03-03T04:59:55.723" v="658" actId="1076"/>
          <ac:spMkLst>
            <pc:docMk/>
            <pc:sldMk cId="2463354579" sldId="739"/>
            <ac:spMk id="5" creationId="{5982B7F3-D588-1C82-E5B8-12A76A8027E6}"/>
          </ac:spMkLst>
        </pc:spChg>
        <pc:picChg chg="add mod">
          <ac:chgData name="健" userId="845497175cb2f617" providerId="LiveId" clId="{248CE05B-4D93-443E-B6EF-ADB2E83653D1}" dt="2023-03-03T04:26:20.258" v="339" actId="1076"/>
          <ac:picMkLst>
            <pc:docMk/>
            <pc:sldMk cId="2463354579" sldId="739"/>
            <ac:picMk id="3" creationId="{FC8043F3-8A01-2FBE-5416-5C3FEF8D137C}"/>
          </ac:picMkLst>
        </pc:picChg>
        <pc:picChg chg="add mod">
          <ac:chgData name="健" userId="845497175cb2f617" providerId="LiveId" clId="{248CE05B-4D93-443E-B6EF-ADB2E83653D1}" dt="2023-03-03T04:59:27.529" v="646" actId="1076"/>
          <ac:picMkLst>
            <pc:docMk/>
            <pc:sldMk cId="2463354579" sldId="739"/>
            <ac:picMk id="6" creationId="{1E0398F5-7ADC-98F2-6BDB-5510ED24D4BB}"/>
          </ac:picMkLst>
        </pc:picChg>
      </pc:sldChg>
      <pc:sldChg chg="addSp delSp modSp new mod">
        <pc:chgData name="健" userId="845497175cb2f617" providerId="LiveId" clId="{248CE05B-4D93-443E-B6EF-ADB2E83653D1}" dt="2023-03-03T23:33:12.618" v="942" actId="20577"/>
        <pc:sldMkLst>
          <pc:docMk/>
          <pc:sldMk cId="2024489355" sldId="740"/>
        </pc:sldMkLst>
        <pc:spChg chg="del">
          <ac:chgData name="健" userId="845497175cb2f617" providerId="LiveId" clId="{248CE05B-4D93-443E-B6EF-ADB2E83653D1}" dt="2023-03-03T04:35:55.290" v="429" actId="478"/>
          <ac:spMkLst>
            <pc:docMk/>
            <pc:sldMk cId="2024489355" sldId="740"/>
            <ac:spMk id="2" creationId="{94DA32DD-A2B0-9326-187A-9E373DF668A6}"/>
          </ac:spMkLst>
        </pc:spChg>
        <pc:spChg chg="del">
          <ac:chgData name="健" userId="845497175cb2f617" providerId="LiveId" clId="{248CE05B-4D93-443E-B6EF-ADB2E83653D1}" dt="2023-03-03T04:35:56.785" v="430" actId="478"/>
          <ac:spMkLst>
            <pc:docMk/>
            <pc:sldMk cId="2024489355" sldId="740"/>
            <ac:spMk id="3" creationId="{4AB70A2E-62C1-7694-2549-9935585C0D77}"/>
          </ac:spMkLst>
        </pc:spChg>
        <pc:spChg chg="add mod">
          <ac:chgData name="健" userId="845497175cb2f617" providerId="LiveId" clId="{248CE05B-4D93-443E-B6EF-ADB2E83653D1}" dt="2023-03-03T23:33:12.618" v="942" actId="20577"/>
          <ac:spMkLst>
            <pc:docMk/>
            <pc:sldMk cId="2024489355" sldId="740"/>
            <ac:spMk id="4" creationId="{8A0A3E2D-7DDE-8E56-B303-C50984FCF018}"/>
          </ac:spMkLst>
        </pc:spChg>
        <pc:spChg chg="add del mod">
          <ac:chgData name="健" userId="845497175cb2f617" providerId="LiveId" clId="{248CE05B-4D93-443E-B6EF-ADB2E83653D1}" dt="2023-03-03T04:44:04.740" v="471" actId="478"/>
          <ac:spMkLst>
            <pc:docMk/>
            <pc:sldMk cId="2024489355" sldId="740"/>
            <ac:spMk id="8" creationId="{BE4DF95D-CE1D-495D-21F6-0AE9CE4932E1}"/>
          </ac:spMkLst>
        </pc:spChg>
        <pc:spChg chg="add mod">
          <ac:chgData name="健" userId="845497175cb2f617" providerId="LiveId" clId="{248CE05B-4D93-443E-B6EF-ADB2E83653D1}" dt="2023-03-03T05:04:34.245" v="702" actId="1076"/>
          <ac:spMkLst>
            <pc:docMk/>
            <pc:sldMk cId="2024489355" sldId="740"/>
            <ac:spMk id="9" creationId="{B8F6874F-7104-D014-04CD-4AD44A26A7AD}"/>
          </ac:spMkLst>
        </pc:spChg>
        <pc:spChg chg="add mod">
          <ac:chgData name="健" userId="845497175cb2f617" providerId="LiveId" clId="{248CE05B-4D93-443E-B6EF-ADB2E83653D1}" dt="2023-03-03T05:05:25.944" v="714" actId="14100"/>
          <ac:spMkLst>
            <pc:docMk/>
            <pc:sldMk cId="2024489355" sldId="740"/>
            <ac:spMk id="11" creationId="{D67705C0-7BD6-7E67-5B45-531BD5F7B771}"/>
          </ac:spMkLst>
        </pc:spChg>
        <pc:spChg chg="add mod">
          <ac:chgData name="健" userId="845497175cb2f617" providerId="LiveId" clId="{248CE05B-4D93-443E-B6EF-ADB2E83653D1}" dt="2023-03-03T05:24:43.622" v="893" actId="14100"/>
          <ac:spMkLst>
            <pc:docMk/>
            <pc:sldMk cId="2024489355" sldId="740"/>
            <ac:spMk id="14" creationId="{3E46744F-B00F-CE83-328D-407B17EDC5E6}"/>
          </ac:spMkLst>
        </pc:spChg>
        <pc:spChg chg="add mod">
          <ac:chgData name="健" userId="845497175cb2f617" providerId="LiveId" clId="{248CE05B-4D93-443E-B6EF-ADB2E83653D1}" dt="2023-03-03T05:25:01.412" v="898" actId="14100"/>
          <ac:spMkLst>
            <pc:docMk/>
            <pc:sldMk cId="2024489355" sldId="740"/>
            <ac:spMk id="16" creationId="{8E0508CF-04B8-2D57-3E55-8FD8D87C0BCE}"/>
          </ac:spMkLst>
        </pc:spChg>
        <pc:picChg chg="add mod">
          <ac:chgData name="健" userId="845497175cb2f617" providerId="LiveId" clId="{248CE05B-4D93-443E-B6EF-ADB2E83653D1}" dt="2023-03-03T05:04:08.412" v="689" actId="1076"/>
          <ac:picMkLst>
            <pc:docMk/>
            <pc:sldMk cId="2024489355" sldId="740"/>
            <ac:picMk id="6" creationId="{30B720F9-D8A1-1FA7-61F7-7347393D0D8C}"/>
          </ac:picMkLst>
        </pc:picChg>
        <pc:picChg chg="add mod">
          <ac:chgData name="健" userId="845497175cb2f617" providerId="LiveId" clId="{248CE05B-4D93-443E-B6EF-ADB2E83653D1}" dt="2023-03-03T04:43:50.035" v="468" actId="1076"/>
          <ac:picMkLst>
            <pc:docMk/>
            <pc:sldMk cId="2024489355" sldId="740"/>
            <ac:picMk id="7" creationId="{5DF55C7F-2700-B0A7-BBD1-945B1FE41F92}"/>
          </ac:picMkLst>
        </pc:picChg>
        <pc:picChg chg="add mod">
          <ac:chgData name="健" userId="845497175cb2f617" providerId="LiveId" clId="{248CE05B-4D93-443E-B6EF-ADB2E83653D1}" dt="2023-03-03T05:04:04.295" v="687" actId="1076"/>
          <ac:picMkLst>
            <pc:docMk/>
            <pc:sldMk cId="2024489355" sldId="740"/>
            <ac:picMk id="10" creationId="{D6D53709-B825-DA93-8638-F5C415F1FEF9}"/>
          </ac:picMkLst>
        </pc:picChg>
        <pc:picChg chg="add mod">
          <ac:chgData name="健" userId="845497175cb2f617" providerId="LiveId" clId="{248CE05B-4D93-443E-B6EF-ADB2E83653D1}" dt="2023-03-03T05:05:03.367" v="704" actId="1076"/>
          <ac:picMkLst>
            <pc:docMk/>
            <pc:sldMk cId="2024489355" sldId="740"/>
            <ac:picMk id="12" creationId="{50E83939-4AAF-5A7E-F122-D928AB142AC9}"/>
          </ac:picMkLst>
        </pc:picChg>
      </pc:sldChg>
      <pc:sldChg chg="addSp delSp modSp mod">
        <pc:chgData name="健" userId="845497175cb2f617" providerId="LiveId" clId="{248CE05B-4D93-443E-B6EF-ADB2E83653D1}" dt="2023-03-03T05:25:39.206" v="906" actId="1076"/>
        <pc:sldMkLst>
          <pc:docMk/>
          <pc:sldMk cId="1509419233" sldId="741"/>
        </pc:sldMkLst>
        <pc:spChg chg="add del mod">
          <ac:chgData name="健" userId="845497175cb2f617" providerId="LiveId" clId="{248CE05B-4D93-443E-B6EF-ADB2E83653D1}" dt="2023-03-03T04:43:34.460" v="464" actId="21"/>
          <ac:spMkLst>
            <pc:docMk/>
            <pc:sldMk cId="1509419233" sldId="741"/>
            <ac:spMk id="4" creationId="{94C2F6C9-2CDD-A9A8-62D6-06C313EF2B08}"/>
          </ac:spMkLst>
        </pc:spChg>
        <pc:spChg chg="add mod">
          <ac:chgData name="健" userId="845497175cb2f617" providerId="LiveId" clId="{248CE05B-4D93-443E-B6EF-ADB2E83653D1}" dt="2023-03-03T05:25:20.290" v="900" actId="14100"/>
          <ac:spMkLst>
            <pc:docMk/>
            <pc:sldMk cId="1509419233" sldId="741"/>
            <ac:spMk id="9" creationId="{2B58B40F-314F-FEE0-A69D-F6482FA06622}"/>
          </ac:spMkLst>
        </pc:spChg>
        <pc:spChg chg="add mod">
          <ac:chgData name="健" userId="845497175cb2f617" providerId="LiveId" clId="{248CE05B-4D93-443E-B6EF-ADB2E83653D1}" dt="2023-03-03T05:06:51.129" v="729" actId="1076"/>
          <ac:spMkLst>
            <pc:docMk/>
            <pc:sldMk cId="1509419233" sldId="741"/>
            <ac:spMk id="10" creationId="{5922295F-3538-220C-070B-81E478339BA4}"/>
          </ac:spMkLst>
        </pc:spChg>
        <pc:spChg chg="add mod">
          <ac:chgData name="健" userId="845497175cb2f617" providerId="LiveId" clId="{248CE05B-4D93-443E-B6EF-ADB2E83653D1}" dt="2023-03-03T05:07:35.166" v="743" actId="1076"/>
          <ac:spMkLst>
            <pc:docMk/>
            <pc:sldMk cId="1509419233" sldId="741"/>
            <ac:spMk id="12" creationId="{DD2961C1-94E4-B9D8-029E-7286FE8309CB}"/>
          </ac:spMkLst>
        </pc:spChg>
        <pc:spChg chg="add mod">
          <ac:chgData name="健" userId="845497175cb2f617" providerId="LiveId" clId="{248CE05B-4D93-443E-B6EF-ADB2E83653D1}" dt="2023-03-03T05:25:39.206" v="906" actId="1076"/>
          <ac:spMkLst>
            <pc:docMk/>
            <pc:sldMk cId="1509419233" sldId="741"/>
            <ac:spMk id="15" creationId="{E1E0B3CD-6FF4-94C5-F488-B60A8FEE2FDB}"/>
          </ac:spMkLst>
        </pc:spChg>
        <pc:picChg chg="add del mod">
          <ac:chgData name="健" userId="845497175cb2f617" providerId="LiveId" clId="{248CE05B-4D93-443E-B6EF-ADB2E83653D1}" dt="2023-03-03T04:43:34.460" v="464" actId="21"/>
          <ac:picMkLst>
            <pc:docMk/>
            <pc:sldMk cId="1509419233" sldId="741"/>
            <ac:picMk id="3" creationId="{7C2B0AA3-B9F7-F47A-BBA8-159029F8D4C1}"/>
          </ac:picMkLst>
        </pc:picChg>
        <pc:picChg chg="add mod">
          <ac:chgData name="健" userId="845497175cb2f617" providerId="LiveId" clId="{248CE05B-4D93-443E-B6EF-ADB2E83653D1}" dt="2023-03-03T04:46:54.951" v="481" actId="1076"/>
          <ac:picMkLst>
            <pc:docMk/>
            <pc:sldMk cId="1509419233" sldId="741"/>
            <ac:picMk id="6" creationId="{D796A5F4-A9D2-2545-2E2F-9B2AA41BE384}"/>
          </ac:picMkLst>
        </pc:picChg>
        <pc:picChg chg="add mod">
          <ac:chgData name="健" userId="845497175cb2f617" providerId="LiveId" clId="{248CE05B-4D93-443E-B6EF-ADB2E83653D1}" dt="2023-03-03T04:47:47.259" v="483" actId="1076"/>
          <ac:picMkLst>
            <pc:docMk/>
            <pc:sldMk cId="1509419233" sldId="741"/>
            <ac:picMk id="8" creationId="{49887D7A-1AE6-DFBA-E358-FD18C5E9078B}"/>
          </ac:picMkLst>
        </pc:picChg>
        <pc:picChg chg="add mod">
          <ac:chgData name="健" userId="845497175cb2f617" providerId="LiveId" clId="{248CE05B-4D93-443E-B6EF-ADB2E83653D1}" dt="2023-03-03T05:05:42.545" v="716" actId="1076"/>
          <ac:picMkLst>
            <pc:docMk/>
            <pc:sldMk cId="1509419233" sldId="741"/>
            <ac:picMk id="11" creationId="{DCB1E8FC-73D2-563E-A29B-B10FB8C323B5}"/>
          </ac:picMkLst>
        </pc:picChg>
        <pc:picChg chg="add mod">
          <ac:chgData name="健" userId="845497175cb2f617" providerId="LiveId" clId="{248CE05B-4D93-443E-B6EF-ADB2E83653D1}" dt="2023-03-03T05:07:10.207" v="731" actId="1076"/>
          <ac:picMkLst>
            <pc:docMk/>
            <pc:sldMk cId="1509419233" sldId="741"/>
            <ac:picMk id="13" creationId="{99ABFCFC-9091-D10F-5367-3F02A35D1BE8}"/>
          </ac:picMkLst>
        </pc:picChg>
      </pc:sldChg>
      <pc:sldChg chg="del">
        <pc:chgData name="健" userId="845497175cb2f617" providerId="LiveId" clId="{248CE05B-4D93-443E-B6EF-ADB2E83653D1}" dt="2023-03-03T05:25:50.583" v="909" actId="2696"/>
        <pc:sldMkLst>
          <pc:docMk/>
          <pc:sldMk cId="3146948054" sldId="742"/>
        </pc:sldMkLst>
      </pc:sldChg>
      <pc:sldChg chg="addSp modSp mod">
        <pc:chgData name="健" userId="845497175cb2f617" providerId="LiveId" clId="{248CE05B-4D93-443E-B6EF-ADB2E83653D1}" dt="2023-03-03T05:25:47.291" v="908" actId="1076"/>
        <pc:sldMkLst>
          <pc:docMk/>
          <pc:sldMk cId="4162826778" sldId="743"/>
        </pc:sldMkLst>
        <pc:spChg chg="add mod">
          <ac:chgData name="健" userId="845497175cb2f617" providerId="LiveId" clId="{248CE05B-4D93-443E-B6EF-ADB2E83653D1}" dt="2023-03-03T05:25:47.291" v="908" actId="1076"/>
          <ac:spMkLst>
            <pc:docMk/>
            <pc:sldMk cId="4162826778" sldId="743"/>
            <ac:spMk id="4" creationId="{BE7E9B53-8A0D-DD7C-2EDD-457B6CFFBD94}"/>
          </ac:spMkLst>
        </pc:spChg>
        <pc:spChg chg="add mod">
          <ac:chgData name="健" userId="845497175cb2f617" providerId="LiveId" clId="{248CE05B-4D93-443E-B6EF-ADB2E83653D1}" dt="2023-03-03T05:08:08.064" v="759" actId="1076"/>
          <ac:spMkLst>
            <pc:docMk/>
            <pc:sldMk cId="4162826778" sldId="743"/>
            <ac:spMk id="5" creationId="{BC3CFEE9-C57A-1D3F-4C01-BB619FFA5E91}"/>
          </ac:spMkLst>
        </pc:spChg>
        <pc:picChg chg="add">
          <ac:chgData name="健" userId="845497175cb2f617" providerId="LiveId" clId="{248CE05B-4D93-443E-B6EF-ADB2E83653D1}" dt="2023-03-03T04:52:31.385" v="531" actId="22"/>
          <ac:picMkLst>
            <pc:docMk/>
            <pc:sldMk cId="4162826778" sldId="743"/>
            <ac:picMk id="3" creationId="{51355409-83C7-80D3-AB83-176918F0E0F2}"/>
          </ac:picMkLst>
        </pc:picChg>
        <pc:picChg chg="add mod">
          <ac:chgData name="健" userId="845497175cb2f617" providerId="LiveId" clId="{248CE05B-4D93-443E-B6EF-ADB2E83653D1}" dt="2023-03-03T05:07:47.535" v="745" actId="1076"/>
          <ac:picMkLst>
            <pc:docMk/>
            <pc:sldMk cId="4162826778" sldId="743"/>
            <ac:picMk id="6" creationId="{6353B443-F978-4913-C169-422D803F95FC}"/>
          </ac:picMkLst>
        </pc:picChg>
      </pc:sldChg>
      <pc:sldChg chg="addSp delSp modSp mod">
        <pc:chgData name="健" userId="845497175cb2f617" providerId="LiveId" clId="{248CE05B-4D93-443E-B6EF-ADB2E83653D1}" dt="2023-03-14T00:24:28.870" v="1200" actId="1076"/>
        <pc:sldMkLst>
          <pc:docMk/>
          <pc:sldMk cId="3596372726" sldId="744"/>
        </pc:sldMkLst>
        <pc:spChg chg="mod">
          <ac:chgData name="健" userId="845497175cb2f617" providerId="LiveId" clId="{248CE05B-4D93-443E-B6EF-ADB2E83653D1}" dt="2023-03-13T23:54:31.366" v="1022" actId="1076"/>
          <ac:spMkLst>
            <pc:docMk/>
            <pc:sldMk cId="3596372726" sldId="744"/>
            <ac:spMk id="3" creationId="{0458690F-AAD7-404E-1686-5D3B2C5A855F}"/>
          </ac:spMkLst>
        </pc:spChg>
        <pc:spChg chg="add mod">
          <ac:chgData name="健" userId="845497175cb2f617" providerId="LiveId" clId="{248CE05B-4D93-443E-B6EF-ADB2E83653D1}" dt="2023-03-14T00:24:28.870" v="1200" actId="1076"/>
          <ac:spMkLst>
            <pc:docMk/>
            <pc:sldMk cId="3596372726" sldId="744"/>
            <ac:spMk id="16" creationId="{D29E2925-0467-58F1-9782-40DC94EFFA51}"/>
          </ac:spMkLst>
        </pc:spChg>
        <pc:spChg chg="add mod">
          <ac:chgData name="健" userId="845497175cb2f617" providerId="LiveId" clId="{248CE05B-4D93-443E-B6EF-ADB2E83653D1}" dt="2023-03-14T00:24:28.870" v="1200" actId="1076"/>
          <ac:spMkLst>
            <pc:docMk/>
            <pc:sldMk cId="3596372726" sldId="744"/>
            <ac:spMk id="17" creationId="{E7A94671-B44E-DE9F-4137-1FF75F7FD95A}"/>
          </ac:spMkLst>
        </pc:spChg>
        <pc:spChg chg="add mod">
          <ac:chgData name="健" userId="845497175cb2f617" providerId="LiveId" clId="{248CE05B-4D93-443E-B6EF-ADB2E83653D1}" dt="2023-03-14T00:24:28.870" v="1200" actId="1076"/>
          <ac:spMkLst>
            <pc:docMk/>
            <pc:sldMk cId="3596372726" sldId="744"/>
            <ac:spMk id="18" creationId="{D8D569F3-E8A5-DD02-DC87-2F81C8BB62FD}"/>
          </ac:spMkLst>
        </pc:spChg>
        <pc:spChg chg="add mod">
          <ac:chgData name="健" userId="845497175cb2f617" providerId="LiveId" clId="{248CE05B-4D93-443E-B6EF-ADB2E83653D1}" dt="2023-03-14T00:24:28.870" v="1200" actId="1076"/>
          <ac:spMkLst>
            <pc:docMk/>
            <pc:sldMk cId="3596372726" sldId="744"/>
            <ac:spMk id="19" creationId="{EF11774F-B4D8-5431-214F-51C767358AB6}"/>
          </ac:spMkLst>
        </pc:spChg>
        <pc:spChg chg="add mod">
          <ac:chgData name="健" userId="845497175cb2f617" providerId="LiveId" clId="{248CE05B-4D93-443E-B6EF-ADB2E83653D1}" dt="2023-03-14T00:24:28.870" v="1200" actId="1076"/>
          <ac:spMkLst>
            <pc:docMk/>
            <pc:sldMk cId="3596372726" sldId="744"/>
            <ac:spMk id="20" creationId="{7C025003-C2C6-2BFC-389B-4321CC518E4E}"/>
          </ac:spMkLst>
        </pc:spChg>
        <pc:spChg chg="add mod">
          <ac:chgData name="健" userId="845497175cb2f617" providerId="LiveId" clId="{248CE05B-4D93-443E-B6EF-ADB2E83653D1}" dt="2023-03-14T00:24:28.870" v="1200" actId="1076"/>
          <ac:spMkLst>
            <pc:docMk/>
            <pc:sldMk cId="3596372726" sldId="744"/>
            <ac:spMk id="21" creationId="{810AA6FF-6799-03C8-B485-C92F2F8EBA5F}"/>
          </ac:spMkLst>
        </pc:spChg>
        <pc:spChg chg="add mod">
          <ac:chgData name="健" userId="845497175cb2f617" providerId="LiveId" clId="{248CE05B-4D93-443E-B6EF-ADB2E83653D1}" dt="2023-03-14T00:24:28.870" v="1200" actId="1076"/>
          <ac:spMkLst>
            <pc:docMk/>
            <pc:sldMk cId="3596372726" sldId="744"/>
            <ac:spMk id="22" creationId="{945F4D6F-2ACB-BA84-0488-612889AD2E26}"/>
          </ac:spMkLst>
        </pc:spChg>
        <pc:spChg chg="add mod">
          <ac:chgData name="健" userId="845497175cb2f617" providerId="LiveId" clId="{248CE05B-4D93-443E-B6EF-ADB2E83653D1}" dt="2023-03-14T00:24:28.870" v="1200" actId="1076"/>
          <ac:spMkLst>
            <pc:docMk/>
            <pc:sldMk cId="3596372726" sldId="744"/>
            <ac:spMk id="23" creationId="{D5660DA9-550A-7DF2-BDCC-0763E48D6E60}"/>
          </ac:spMkLst>
        </pc:spChg>
        <pc:spChg chg="add mod">
          <ac:chgData name="健" userId="845497175cb2f617" providerId="LiveId" clId="{248CE05B-4D93-443E-B6EF-ADB2E83653D1}" dt="2023-03-14T00:24:28.870" v="1200" actId="1076"/>
          <ac:spMkLst>
            <pc:docMk/>
            <pc:sldMk cId="3596372726" sldId="744"/>
            <ac:spMk id="24" creationId="{1D8C1250-CA4C-6495-F693-82951AF9E30C}"/>
          </ac:spMkLst>
        </pc:spChg>
        <pc:spChg chg="add mod">
          <ac:chgData name="健" userId="845497175cb2f617" providerId="LiveId" clId="{248CE05B-4D93-443E-B6EF-ADB2E83653D1}" dt="2023-03-14T00:24:28.870" v="1200" actId="1076"/>
          <ac:spMkLst>
            <pc:docMk/>
            <pc:sldMk cId="3596372726" sldId="744"/>
            <ac:spMk id="25" creationId="{AE38D59E-F622-93A0-B4E3-1997796F7045}"/>
          </ac:spMkLst>
        </pc:spChg>
        <pc:spChg chg="add mod">
          <ac:chgData name="健" userId="845497175cb2f617" providerId="LiveId" clId="{248CE05B-4D93-443E-B6EF-ADB2E83653D1}" dt="2023-03-14T00:24:28.870" v="1200" actId="1076"/>
          <ac:spMkLst>
            <pc:docMk/>
            <pc:sldMk cId="3596372726" sldId="744"/>
            <ac:spMk id="26" creationId="{F08CBA26-C8BB-4D07-6F7B-D6F2EDE960F0}"/>
          </ac:spMkLst>
        </pc:spChg>
        <pc:spChg chg="add mod">
          <ac:chgData name="健" userId="845497175cb2f617" providerId="LiveId" clId="{248CE05B-4D93-443E-B6EF-ADB2E83653D1}" dt="2023-03-14T00:24:28.870" v="1200" actId="1076"/>
          <ac:spMkLst>
            <pc:docMk/>
            <pc:sldMk cId="3596372726" sldId="744"/>
            <ac:spMk id="27" creationId="{38EF7F53-CEAB-95D8-AF9E-DFE1C621B030}"/>
          </ac:spMkLst>
        </pc:spChg>
        <pc:spChg chg="add mod">
          <ac:chgData name="健" userId="845497175cb2f617" providerId="LiveId" clId="{248CE05B-4D93-443E-B6EF-ADB2E83653D1}" dt="2023-03-14T00:24:28.870" v="1200" actId="1076"/>
          <ac:spMkLst>
            <pc:docMk/>
            <pc:sldMk cId="3596372726" sldId="744"/>
            <ac:spMk id="28" creationId="{6D9C5900-548D-C9AD-3443-91011F4F9190}"/>
          </ac:spMkLst>
        </pc:spChg>
        <pc:picChg chg="del mod modCrop">
          <ac:chgData name="健" userId="845497175cb2f617" providerId="LiveId" clId="{248CE05B-4D93-443E-B6EF-ADB2E83653D1}" dt="2023-03-13T23:55:12.954" v="1027" actId="478"/>
          <ac:picMkLst>
            <pc:docMk/>
            <pc:sldMk cId="3596372726" sldId="744"/>
            <ac:picMk id="2" creationId="{FDE502C8-7C37-B3BA-89BB-DB123DC1C8BE}"/>
          </ac:picMkLst>
        </pc:picChg>
        <pc:picChg chg="del">
          <ac:chgData name="健" userId="845497175cb2f617" providerId="LiveId" clId="{248CE05B-4D93-443E-B6EF-ADB2E83653D1}" dt="2023-03-13T23:45:25.316" v="997" actId="21"/>
          <ac:picMkLst>
            <pc:docMk/>
            <pc:sldMk cId="3596372726" sldId="744"/>
            <ac:picMk id="4" creationId="{6CF5FE97-D0E2-7CB3-FFB3-B153372C109A}"/>
          </ac:picMkLst>
        </pc:picChg>
        <pc:picChg chg="del">
          <ac:chgData name="健" userId="845497175cb2f617" providerId="LiveId" clId="{248CE05B-4D93-443E-B6EF-ADB2E83653D1}" dt="2023-03-13T23:45:15.116" v="996" actId="21"/>
          <ac:picMkLst>
            <pc:docMk/>
            <pc:sldMk cId="3596372726" sldId="744"/>
            <ac:picMk id="5" creationId="{E8BDB5FE-EDE2-22B5-0B18-FEB824F82DC9}"/>
          </ac:picMkLst>
        </pc:picChg>
        <pc:picChg chg="del mod">
          <ac:chgData name="健" userId="845497175cb2f617" providerId="LiveId" clId="{248CE05B-4D93-443E-B6EF-ADB2E83653D1}" dt="2023-03-13T23:55:12.954" v="1027" actId="478"/>
          <ac:picMkLst>
            <pc:docMk/>
            <pc:sldMk cId="3596372726" sldId="744"/>
            <ac:picMk id="6" creationId="{0E98E31B-4200-FA1E-2ACE-94183B937D25}"/>
          </ac:picMkLst>
        </pc:picChg>
        <pc:picChg chg="del mod">
          <ac:chgData name="健" userId="845497175cb2f617" providerId="LiveId" clId="{248CE05B-4D93-443E-B6EF-ADB2E83653D1}" dt="2023-03-13T23:55:12.954" v="1027" actId="478"/>
          <ac:picMkLst>
            <pc:docMk/>
            <pc:sldMk cId="3596372726" sldId="744"/>
            <ac:picMk id="7" creationId="{9915B834-181A-D5F0-20D3-94A268616715}"/>
          </ac:picMkLst>
        </pc:picChg>
        <pc:picChg chg="del mod modCrop">
          <ac:chgData name="健" userId="845497175cb2f617" providerId="LiveId" clId="{248CE05B-4D93-443E-B6EF-ADB2E83653D1}" dt="2023-03-13T23:55:12.954" v="1027" actId="478"/>
          <ac:picMkLst>
            <pc:docMk/>
            <pc:sldMk cId="3596372726" sldId="744"/>
            <ac:picMk id="8" creationId="{D0058BCD-6AEE-8187-F36D-40A130FE41DA}"/>
          </ac:picMkLst>
        </pc:picChg>
        <pc:picChg chg="del mod">
          <ac:chgData name="健" userId="845497175cb2f617" providerId="LiveId" clId="{248CE05B-4D93-443E-B6EF-ADB2E83653D1}" dt="2023-03-13T23:55:12.954" v="1027" actId="478"/>
          <ac:picMkLst>
            <pc:docMk/>
            <pc:sldMk cId="3596372726" sldId="744"/>
            <ac:picMk id="9" creationId="{1CABE55A-3CB2-F9DB-BAAD-FB174F733FAF}"/>
          </ac:picMkLst>
        </pc:picChg>
        <pc:picChg chg="del mod">
          <ac:chgData name="健" userId="845497175cb2f617" providerId="LiveId" clId="{248CE05B-4D93-443E-B6EF-ADB2E83653D1}" dt="2023-03-13T23:55:12.954" v="1027" actId="478"/>
          <ac:picMkLst>
            <pc:docMk/>
            <pc:sldMk cId="3596372726" sldId="744"/>
            <ac:picMk id="10" creationId="{A00EE368-E6D8-F2C8-8203-D55DF3EC879F}"/>
          </ac:picMkLst>
        </pc:picChg>
        <pc:picChg chg="del mod">
          <ac:chgData name="健" userId="845497175cb2f617" providerId="LiveId" clId="{248CE05B-4D93-443E-B6EF-ADB2E83653D1}" dt="2023-03-13T23:55:12.954" v="1027" actId="478"/>
          <ac:picMkLst>
            <pc:docMk/>
            <pc:sldMk cId="3596372726" sldId="744"/>
            <ac:picMk id="11" creationId="{A91852B9-6291-6392-A798-1B7A611A62A3}"/>
          </ac:picMkLst>
        </pc:picChg>
        <pc:picChg chg="del mod">
          <ac:chgData name="健" userId="845497175cb2f617" providerId="LiveId" clId="{248CE05B-4D93-443E-B6EF-ADB2E83653D1}" dt="2023-03-13T23:55:12.954" v="1027" actId="478"/>
          <ac:picMkLst>
            <pc:docMk/>
            <pc:sldMk cId="3596372726" sldId="744"/>
            <ac:picMk id="12" creationId="{7AED0E3E-0561-1634-4ABF-8029D84DAAAB}"/>
          </ac:picMkLst>
        </pc:picChg>
        <pc:picChg chg="del mod">
          <ac:chgData name="健" userId="845497175cb2f617" providerId="LiveId" clId="{248CE05B-4D93-443E-B6EF-ADB2E83653D1}" dt="2023-03-13T23:55:12.954" v="1027" actId="478"/>
          <ac:picMkLst>
            <pc:docMk/>
            <pc:sldMk cId="3596372726" sldId="744"/>
            <ac:picMk id="13" creationId="{1C2A20CC-C709-3FE1-0477-B26D7D237181}"/>
          </ac:picMkLst>
        </pc:picChg>
        <pc:picChg chg="add del mod modCrop">
          <ac:chgData name="健" userId="845497175cb2f617" providerId="LiveId" clId="{248CE05B-4D93-443E-B6EF-ADB2E83653D1}" dt="2023-03-13T23:55:12.954" v="1027" actId="478"/>
          <ac:picMkLst>
            <pc:docMk/>
            <pc:sldMk cId="3596372726" sldId="744"/>
            <ac:picMk id="14" creationId="{07B3676A-5233-468B-3915-1EA8172D88A1}"/>
          </ac:picMkLst>
        </pc:picChg>
        <pc:picChg chg="add mod modCrop">
          <ac:chgData name="健" userId="845497175cb2f617" providerId="LiveId" clId="{248CE05B-4D93-443E-B6EF-ADB2E83653D1}" dt="2023-03-14T00:24:28.870" v="1200" actId="1076"/>
          <ac:picMkLst>
            <pc:docMk/>
            <pc:sldMk cId="3596372726" sldId="744"/>
            <ac:picMk id="15" creationId="{753F58AA-3A53-743D-422D-3D160995173F}"/>
          </ac:picMkLst>
        </pc:picChg>
      </pc:sldChg>
    </pc:docChg>
  </pc:docChgLst>
  <pc:docChgLst>
    <pc:chgData name="健" userId="845497175cb2f617" providerId="LiveId" clId="{6E44B5D2-5F61-4668-81E7-80AA2B6E01C7}"/>
    <pc:docChg chg="modSld">
      <pc:chgData name="健" userId="845497175cb2f617" providerId="LiveId" clId="{6E44B5D2-5F61-4668-81E7-80AA2B6E01C7}" dt="2023-03-29T23:07:41.224" v="5" actId="13926"/>
      <pc:docMkLst>
        <pc:docMk/>
      </pc:docMkLst>
      <pc:sldChg chg="modSp mod">
        <pc:chgData name="健" userId="845497175cb2f617" providerId="LiveId" clId="{6E44B5D2-5F61-4668-81E7-80AA2B6E01C7}" dt="2023-03-29T23:07:25.777" v="4" actId="20577"/>
        <pc:sldMkLst>
          <pc:docMk/>
          <pc:sldMk cId="2787273873" sldId="732"/>
        </pc:sldMkLst>
        <pc:spChg chg="mod">
          <ac:chgData name="健" userId="845497175cb2f617" providerId="LiveId" clId="{6E44B5D2-5F61-4668-81E7-80AA2B6E01C7}" dt="2023-03-29T23:07:25.777" v="4" actId="20577"/>
          <ac:spMkLst>
            <pc:docMk/>
            <pc:sldMk cId="2787273873" sldId="732"/>
            <ac:spMk id="2" creationId="{B3203020-206B-F9C7-D819-E053BB6FB2B5}"/>
          </ac:spMkLst>
        </pc:spChg>
      </pc:sldChg>
      <pc:sldChg chg="modSp mod">
        <pc:chgData name="健" userId="845497175cb2f617" providerId="LiveId" clId="{6E44B5D2-5F61-4668-81E7-80AA2B6E01C7}" dt="2023-03-29T23:07:41.224" v="5" actId="13926"/>
        <pc:sldMkLst>
          <pc:docMk/>
          <pc:sldMk cId="2896534360" sldId="733"/>
        </pc:sldMkLst>
        <pc:spChg chg="mod">
          <ac:chgData name="健" userId="845497175cb2f617" providerId="LiveId" clId="{6E44B5D2-5F61-4668-81E7-80AA2B6E01C7}" dt="2023-03-29T23:07:41.224" v="5" actId="13926"/>
          <ac:spMkLst>
            <pc:docMk/>
            <pc:sldMk cId="2896534360" sldId="733"/>
            <ac:spMk id="12" creationId="{B9966725-7678-E3FF-5C5A-07FDE6523D98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7D6D97C-2792-4020-9515-6E0AA45DDB0D}" type="datetimeFigureOut">
              <a:rPr kumimoji="1" lang="ja-JP" altLang="en-US" smtClean="0"/>
              <a:t>2023/3/3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829E24E-D854-4662-91C9-F56D3A48BF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74705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829E24E-D854-4662-91C9-F56D3A48BF59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96386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AF2762C-678D-BDD0-9906-BE44A13DCE1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A8E76424-ECA3-A2EE-0751-6F28EA0BF88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FD11BBF-73E9-36C9-FB95-2522F0B104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DECB9-12A1-4661-A780-2A823888BD67}" type="datetimeFigureOut">
              <a:rPr kumimoji="1" lang="ja-JP" altLang="en-US" smtClean="0"/>
              <a:t>2023/3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256B7D3-6BC1-1E29-2C66-44421D7D70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93AAD3A-4C1A-872E-0937-82AE73BA56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6C32C-297C-40B2-AFDA-2BF24058A6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74921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05B3F8F-D71E-C6A6-E475-02E2DF1373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7DF2F1E-FF3D-659F-C408-2DE3C2BD40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0B403F5-8DAE-1A36-C287-3DD483290A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DECB9-12A1-4661-A780-2A823888BD67}" type="datetimeFigureOut">
              <a:rPr kumimoji="1" lang="ja-JP" altLang="en-US" smtClean="0"/>
              <a:t>2023/3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C4597BB-64E8-EF5D-0840-05C5105616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F6C6873-F708-064D-66BB-D47B30130D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6C32C-297C-40B2-AFDA-2BF24058A6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66164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B2E42579-9C23-6873-D5EB-B46CB889383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E1634D2-C3D9-D3DC-5EC8-ABC7AC0C8C3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90659AB-D6C4-4846-8684-DB6597FB88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DECB9-12A1-4661-A780-2A823888BD67}" type="datetimeFigureOut">
              <a:rPr kumimoji="1" lang="ja-JP" altLang="en-US" smtClean="0"/>
              <a:t>2023/3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69F18B5-B474-6B9E-16D8-5C0BAF87C0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D5BD9F6-A82F-612C-E70C-16093590D6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6C32C-297C-40B2-AFDA-2BF24058A6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98958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F5AAEED-2CF9-707D-3ED4-1F7EF4C4E5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19681CC-ACE0-91E2-B01D-66233ACEFD7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13CEB0F-FC9B-DDD5-EDFE-9479891380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DECB9-12A1-4661-A780-2A823888BD67}" type="datetimeFigureOut">
              <a:rPr kumimoji="1" lang="ja-JP" altLang="en-US" smtClean="0"/>
              <a:t>2023/3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3007C86-6C52-ACB4-1018-A549A12FB4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7B1B692-214E-864F-2BC9-FB8A4EB454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6C32C-297C-40B2-AFDA-2BF24058A6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31443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81B3662-B7D4-766C-BD08-8F4FB3FC8E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DD59920-D11F-E467-68C7-B54E01EA02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B0BB068-23A0-3524-6FB7-EAB728DB9F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DECB9-12A1-4661-A780-2A823888BD67}" type="datetimeFigureOut">
              <a:rPr kumimoji="1" lang="ja-JP" altLang="en-US" smtClean="0"/>
              <a:t>2023/3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9F4E411-7FD9-FC59-7BAE-B7571E866A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2875FFD-79AE-0D69-3CCC-90A96C355E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6C32C-297C-40B2-AFDA-2BF24058A6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50623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1EE4122-C8EB-8F94-84BE-93AA0A8EDF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F8770FB-A2EC-F782-86C7-FE045D7A8D5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856E66D-E51B-2B9E-BA8C-1B652105538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F837EED-087F-347D-994C-415F13521F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DECB9-12A1-4661-A780-2A823888BD67}" type="datetimeFigureOut">
              <a:rPr kumimoji="1" lang="ja-JP" altLang="en-US" smtClean="0"/>
              <a:t>2023/3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E523D62-D2A4-5513-A25D-8F038A03A3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A485F8D-86F2-C017-8E41-E6484A2308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6C32C-297C-40B2-AFDA-2BF24058A6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81850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449E686-D967-836B-398F-B307827130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AD62BE8-8540-C8B5-0416-C2800B43F8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E7ECD74-0206-C246-9332-9FBF352E48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2E68D43E-BDD0-712B-3412-58F79758B67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27373A26-7AAC-0141-5B5C-B48EAB2F20D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B29FE520-B063-8C09-C0C5-DB9DE63941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DECB9-12A1-4661-A780-2A823888BD67}" type="datetimeFigureOut">
              <a:rPr kumimoji="1" lang="ja-JP" altLang="en-US" smtClean="0"/>
              <a:t>2023/3/3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FAE93A42-EA7E-171D-FB6A-5E9544EA69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695C0D86-82BE-C04E-6202-6CB633EFBE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6C32C-297C-40B2-AFDA-2BF24058A6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25915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1E974D7-B71C-F3DD-E9BB-08D6EB9436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F6BFB68-42CD-F67D-0D68-E449A11C73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DECB9-12A1-4661-A780-2A823888BD67}" type="datetimeFigureOut">
              <a:rPr kumimoji="1" lang="ja-JP" altLang="en-US" smtClean="0"/>
              <a:t>2023/3/3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268724D-4D10-EAAD-B533-C0CF306FC3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2098BF38-8A93-2FCC-0AE7-D003AC4657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6C32C-297C-40B2-AFDA-2BF24058A6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8372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D04306D8-C4F9-4496-854A-1FDA9CDD5E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DECB9-12A1-4661-A780-2A823888BD67}" type="datetimeFigureOut">
              <a:rPr kumimoji="1" lang="ja-JP" altLang="en-US" smtClean="0"/>
              <a:t>2023/3/3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BC589443-8966-C113-7928-6D68189229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4A9943A7-4A73-E838-AA5A-6471781E69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6C32C-297C-40B2-AFDA-2BF24058A6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15426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B024D0F-1BBE-3F2D-3A78-DA3EBF5666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805C023-ECBE-2DCF-13A2-3E0397CA51C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427C893-0A73-B4E5-B0E9-946A5B90315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AC9D735-A71A-4135-312A-9FDB1D9C95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DECB9-12A1-4661-A780-2A823888BD67}" type="datetimeFigureOut">
              <a:rPr kumimoji="1" lang="ja-JP" altLang="en-US" smtClean="0"/>
              <a:t>2023/3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9594B6B-C405-06B3-B47A-CE793D7472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43D2F54-5924-DB5E-A1A8-19C9C8A165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6C32C-297C-40B2-AFDA-2BF24058A6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92017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322B899-DCD8-1AD4-2E38-87CF8796E7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7199B2B6-9493-2715-2E14-A3B4A5A9001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B3F5C52-7059-4014-C73F-E6A39B58512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19C7BA3-87DC-5F0A-A1D3-46E82729D8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DECB9-12A1-4661-A780-2A823888BD67}" type="datetimeFigureOut">
              <a:rPr kumimoji="1" lang="ja-JP" altLang="en-US" smtClean="0"/>
              <a:t>2023/3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A755832-636A-31B3-BBF9-1930E5B6C8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BBCCAE7-6B00-E66C-D8F1-C7CFBAFCCE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6C32C-297C-40B2-AFDA-2BF24058A6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63808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0A6D28B6-28E2-2AA5-927F-CABF85B06E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75DB297-C1DD-0642-E8B0-A42AC7F2B5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20420A5-71F8-9511-11CC-E44B079E7ED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2DECB9-12A1-4661-A780-2A823888BD67}" type="datetimeFigureOut">
              <a:rPr kumimoji="1" lang="ja-JP" altLang="en-US" smtClean="0"/>
              <a:t>2023/3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655F34F-65AC-86E6-E7D6-02858A92D8A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B230021-8855-F3CA-F298-62CE0F0A5D5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66C32C-297C-40B2-AFDA-2BF24058A6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63810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hyperlink" Target="mailto:arimura.ken@twmu.ac.jp" TargetMode="External"/><Relationship Id="rId3" Type="http://schemas.openxmlformats.org/officeDocument/2006/relationships/image" Target="../media/image1.jpg"/><Relationship Id="rId7" Type="http://schemas.openxmlformats.org/officeDocument/2006/relationships/image" Target="../media/image5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g"/><Relationship Id="rId5" Type="http://schemas.openxmlformats.org/officeDocument/2006/relationships/image" Target="../media/image3.jpg"/><Relationship Id="rId4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 descr="夜空に光っている星&#10;&#10;自動的に生成された説明">
            <a:extLst>
              <a:ext uri="{FF2B5EF4-FFF2-40B4-BE49-F238E27FC236}">
                <a16:creationId xmlns:a16="http://schemas.microsoft.com/office/drawing/2014/main" id="{F968A830-F72A-111D-1C95-0E8736B33B7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169" b="74079"/>
          <a:stretch/>
        </p:blipFill>
        <p:spPr>
          <a:xfrm>
            <a:off x="2693324" y="2556017"/>
            <a:ext cx="1996191" cy="1777685"/>
          </a:xfrm>
          <a:prstGeom prst="rect">
            <a:avLst/>
          </a:prstGeom>
        </p:spPr>
      </p:pic>
      <p:pic>
        <p:nvPicPr>
          <p:cNvPr id="7" name="図 6" descr="夜空の月&#10;&#10;自動的に生成された説明">
            <a:extLst>
              <a:ext uri="{FF2B5EF4-FFF2-40B4-BE49-F238E27FC236}">
                <a16:creationId xmlns:a16="http://schemas.microsoft.com/office/drawing/2014/main" id="{CECB227C-A140-0AF8-720F-462CB922EF5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243" b="74079"/>
          <a:stretch/>
        </p:blipFill>
        <p:spPr>
          <a:xfrm>
            <a:off x="9448802" y="2539255"/>
            <a:ext cx="1989372" cy="1777684"/>
          </a:xfrm>
          <a:prstGeom prst="rect">
            <a:avLst/>
          </a:prstGeom>
        </p:spPr>
      </p:pic>
      <p:pic>
        <p:nvPicPr>
          <p:cNvPr id="9" name="図 8" descr="夜空の星&#10;&#10;自動的に生成された説明">
            <a:extLst>
              <a:ext uri="{FF2B5EF4-FFF2-40B4-BE49-F238E27FC236}">
                <a16:creationId xmlns:a16="http://schemas.microsoft.com/office/drawing/2014/main" id="{CCAA5C62-8F77-0DE7-208A-98873AF8EB09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084" b="73888"/>
          <a:stretch/>
        </p:blipFill>
        <p:spPr>
          <a:xfrm>
            <a:off x="4887884" y="2548375"/>
            <a:ext cx="2004040" cy="1790869"/>
          </a:xfrm>
          <a:prstGeom prst="rect">
            <a:avLst/>
          </a:prstGeom>
        </p:spPr>
      </p:pic>
      <p:pic>
        <p:nvPicPr>
          <p:cNvPr id="11" name="図 10" descr="夜空の星&#10;&#10;自動的に生成された説明">
            <a:extLst>
              <a:ext uri="{FF2B5EF4-FFF2-40B4-BE49-F238E27FC236}">
                <a16:creationId xmlns:a16="http://schemas.microsoft.com/office/drawing/2014/main" id="{68374892-DF0D-192C-11A2-1DB81A1C3B7A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969" r="1" b="73964"/>
          <a:stretch/>
        </p:blipFill>
        <p:spPr>
          <a:xfrm>
            <a:off x="7099070" y="2548585"/>
            <a:ext cx="2014400" cy="1785532"/>
          </a:xfrm>
          <a:prstGeom prst="rect">
            <a:avLst/>
          </a:prstGeom>
        </p:spPr>
      </p:pic>
      <p:pic>
        <p:nvPicPr>
          <p:cNvPr id="13" name="図 12" descr="緑の木々&#10;&#10;中程度の精度で自動的に生成された説明">
            <a:extLst>
              <a:ext uri="{FF2B5EF4-FFF2-40B4-BE49-F238E27FC236}">
                <a16:creationId xmlns:a16="http://schemas.microsoft.com/office/drawing/2014/main" id="{2E62ED13-AE82-A8A4-8B16-290B68668015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192" b="74098"/>
          <a:stretch/>
        </p:blipFill>
        <p:spPr>
          <a:xfrm>
            <a:off x="465512" y="2551850"/>
            <a:ext cx="1994126" cy="1776310"/>
          </a:xfrm>
          <a:prstGeom prst="rect">
            <a:avLst/>
          </a:prstGeom>
        </p:spPr>
      </p:pic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C6335FBE-A975-AA73-2D54-57523D28899E}"/>
              </a:ext>
            </a:extLst>
          </p:cNvPr>
          <p:cNvCxnSpPr>
            <a:cxnSpLocks/>
          </p:cNvCxnSpPr>
          <p:nvPr/>
        </p:nvCxnSpPr>
        <p:spPr>
          <a:xfrm>
            <a:off x="10694967" y="4144088"/>
            <a:ext cx="744279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604D630B-6699-97FB-1077-317A32944F9F}"/>
              </a:ext>
            </a:extLst>
          </p:cNvPr>
          <p:cNvSpPr txBox="1"/>
          <p:nvPr/>
        </p:nvSpPr>
        <p:spPr>
          <a:xfrm>
            <a:off x="10796813" y="4125919"/>
            <a:ext cx="471055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50 μm</a:t>
            </a:r>
            <a:endParaRPr kumimoji="1" lang="ja-JP" altLang="en-US" sz="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A8AA9711-8DC2-11AF-ACEA-FBCE8696DAB4}"/>
              </a:ext>
            </a:extLst>
          </p:cNvPr>
          <p:cNvSpPr txBox="1"/>
          <p:nvPr/>
        </p:nvSpPr>
        <p:spPr>
          <a:xfrm>
            <a:off x="461614" y="2560075"/>
            <a:ext cx="48768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200" b="0" i="1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D4</a:t>
            </a:r>
            <a:endParaRPr lang="ja-JP" altLang="en-US" i="1" dirty="0">
              <a:solidFill>
                <a:schemeClr val="bg1"/>
              </a:solidFill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CC5D9E07-E9CF-9393-E1B9-25AED742D5E0}"/>
              </a:ext>
            </a:extLst>
          </p:cNvPr>
          <p:cNvSpPr txBox="1"/>
          <p:nvPr/>
        </p:nvSpPr>
        <p:spPr>
          <a:xfrm>
            <a:off x="2707179" y="2568679"/>
            <a:ext cx="48768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200" b="0" i="1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D8</a:t>
            </a:r>
            <a:endParaRPr lang="ja-JP" altLang="en-US" i="1" dirty="0">
              <a:solidFill>
                <a:schemeClr val="bg1"/>
              </a:solidFill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86CACB35-94CC-67E9-2176-19D9AA07EF0D}"/>
              </a:ext>
            </a:extLst>
          </p:cNvPr>
          <p:cNvSpPr txBox="1"/>
          <p:nvPr/>
        </p:nvSpPr>
        <p:spPr>
          <a:xfrm>
            <a:off x="4887884" y="2554823"/>
            <a:ext cx="63730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i="1" dirty="0" err="1">
                <a:solidFill>
                  <a:schemeClr val="bg1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LAG3</a:t>
            </a:r>
            <a:endParaRPr lang="ja-JP" altLang="en-US" i="1" dirty="0">
              <a:solidFill>
                <a:schemeClr val="bg1"/>
              </a:solidFill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9C5580B3-7DFD-CE8B-67F6-1AE8C856D105}"/>
              </a:ext>
            </a:extLst>
          </p:cNvPr>
          <p:cNvSpPr txBox="1"/>
          <p:nvPr/>
        </p:nvSpPr>
        <p:spPr>
          <a:xfrm>
            <a:off x="7107383" y="2557595"/>
            <a:ext cx="55695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schemeClr val="bg1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API</a:t>
            </a:r>
            <a:endParaRPr lang="ja-JP" altLang="en-US" dirty="0">
              <a:solidFill>
                <a:schemeClr val="bg1"/>
              </a:solidFill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B0F948CF-85CF-B159-310B-795D97E9E6F5}"/>
              </a:ext>
            </a:extLst>
          </p:cNvPr>
          <p:cNvSpPr txBox="1"/>
          <p:nvPr/>
        </p:nvSpPr>
        <p:spPr>
          <a:xfrm>
            <a:off x="9457115" y="2540969"/>
            <a:ext cx="63730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schemeClr val="bg1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Merge</a:t>
            </a:r>
            <a:endParaRPr lang="ja-JP" altLang="en-US" dirty="0">
              <a:solidFill>
                <a:schemeClr val="bg1"/>
              </a:solidFill>
            </a:endParaRPr>
          </a:p>
        </p:txBody>
      </p: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6A53DB80-0E8F-F050-9853-3470C5ACFE06}"/>
              </a:ext>
            </a:extLst>
          </p:cNvPr>
          <p:cNvCxnSpPr>
            <a:cxnSpLocks/>
          </p:cNvCxnSpPr>
          <p:nvPr/>
        </p:nvCxnSpPr>
        <p:spPr>
          <a:xfrm>
            <a:off x="8359091" y="4169027"/>
            <a:ext cx="744279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3A1C7172-7D46-2D47-C27D-178DD9350B73}"/>
              </a:ext>
            </a:extLst>
          </p:cNvPr>
          <p:cNvSpPr txBox="1"/>
          <p:nvPr/>
        </p:nvSpPr>
        <p:spPr>
          <a:xfrm>
            <a:off x="8460937" y="4150858"/>
            <a:ext cx="471055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50 μm</a:t>
            </a:r>
            <a:endParaRPr kumimoji="1" lang="ja-JP" altLang="en-US" sz="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B766A34E-0955-5913-CEC2-07928D904ECA}"/>
              </a:ext>
            </a:extLst>
          </p:cNvPr>
          <p:cNvCxnSpPr>
            <a:cxnSpLocks/>
          </p:cNvCxnSpPr>
          <p:nvPr/>
        </p:nvCxnSpPr>
        <p:spPr>
          <a:xfrm>
            <a:off x="6153447" y="4169026"/>
            <a:ext cx="744279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5CE12DF6-FF3B-EDA3-CFDC-2EF2CA58D04A}"/>
              </a:ext>
            </a:extLst>
          </p:cNvPr>
          <p:cNvSpPr txBox="1"/>
          <p:nvPr/>
        </p:nvSpPr>
        <p:spPr>
          <a:xfrm>
            <a:off x="6255293" y="4150857"/>
            <a:ext cx="471055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50 μm</a:t>
            </a:r>
            <a:endParaRPr kumimoji="1" lang="ja-JP" altLang="en-US" sz="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5C930660-C364-A5DF-DCA8-107CA3DA69D3}"/>
              </a:ext>
            </a:extLst>
          </p:cNvPr>
          <p:cNvCxnSpPr>
            <a:cxnSpLocks/>
          </p:cNvCxnSpPr>
          <p:nvPr/>
        </p:nvCxnSpPr>
        <p:spPr>
          <a:xfrm>
            <a:off x="3942261" y="4163484"/>
            <a:ext cx="744279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CA11DB6E-1A14-6706-82BB-8C5B955DAE89}"/>
              </a:ext>
            </a:extLst>
          </p:cNvPr>
          <p:cNvSpPr txBox="1"/>
          <p:nvPr/>
        </p:nvSpPr>
        <p:spPr>
          <a:xfrm>
            <a:off x="4044107" y="4145315"/>
            <a:ext cx="471055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50 μm</a:t>
            </a:r>
            <a:endParaRPr kumimoji="1" lang="ja-JP" altLang="en-US" sz="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13B4248E-4D77-2613-00AA-1AE574C781AA}"/>
              </a:ext>
            </a:extLst>
          </p:cNvPr>
          <p:cNvCxnSpPr>
            <a:cxnSpLocks/>
          </p:cNvCxnSpPr>
          <p:nvPr/>
        </p:nvCxnSpPr>
        <p:spPr>
          <a:xfrm>
            <a:off x="1708908" y="4157943"/>
            <a:ext cx="744279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37FF6F2E-2A8D-7DE5-8658-E82EACAD9068}"/>
              </a:ext>
            </a:extLst>
          </p:cNvPr>
          <p:cNvSpPr txBox="1"/>
          <p:nvPr/>
        </p:nvSpPr>
        <p:spPr>
          <a:xfrm>
            <a:off x="1810754" y="4139774"/>
            <a:ext cx="471055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50 μm</a:t>
            </a:r>
            <a:endParaRPr kumimoji="1" lang="ja-JP" altLang="en-US" sz="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57C8DE8A-94D1-18EF-3145-82DCE4A25C32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ja-JP" altLang="en-US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8920F3F-94E7-39A4-FF20-0415E7A0BBF0}"/>
              </a:ext>
            </a:extLst>
          </p:cNvPr>
          <p:cNvSpPr txBox="1"/>
          <p:nvPr/>
        </p:nvSpPr>
        <p:spPr>
          <a:xfrm>
            <a:off x="678872" y="5139327"/>
            <a:ext cx="10670771" cy="11079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US" altLang="ja-JP" sz="12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1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. Representative immunofluorescence images of </a:t>
            </a:r>
            <a:r>
              <a:rPr lang="en-US" altLang="ja-JP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D4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</a:t>
            </a:r>
            <a:r>
              <a:rPr lang="en-US" altLang="ja-JP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D8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and </a:t>
            </a:r>
            <a:r>
              <a:rPr lang="en-US" altLang="ja-JP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AG3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expression and DAPI staining in MPM (20×).</a:t>
            </a:r>
            <a:endParaRPr lang="ja-JP" altLang="ja-JP" sz="1200" dirty="0"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US" altLang="ja-JP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AG3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immunofluorescence expression is from our cohort.</a:t>
            </a:r>
            <a:endParaRPr lang="ja-JP" altLang="ja-JP" sz="1200" dirty="0"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US" altLang="ja-JP" sz="12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PM, malignant pleural mesothelioma </a:t>
            </a:r>
            <a:endParaRPr lang="ja-JP" altLang="ja-JP" sz="1200" dirty="0"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2" name="Rectangle 3">
            <a:extLst>
              <a:ext uri="{FF2B5EF4-FFF2-40B4-BE49-F238E27FC236}">
                <a16:creationId xmlns:a16="http://schemas.microsoft.com/office/drawing/2014/main" id="{B3203020-206B-F9C7-D819-E053BB6FB2B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877" y="40214"/>
            <a:ext cx="11817659" cy="113877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</a:t>
            </a:r>
            <a:r>
              <a:rPr kumimoji="0" lang="en-GB" altLang="ja-JP" sz="16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</a:t>
            </a:r>
            <a:r>
              <a:rPr kumimoji="0" lang="en-US" altLang="ja-JP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terial</a:t>
            </a:r>
            <a:endParaRPr kumimoji="0" lang="en-US" altLang="ja-JP" sz="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600" b="1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LAG3 is a prognostic biomarker and potential target for immune checkpoint inhibitors for patients with malignant pleural mesothelioma </a:t>
            </a:r>
            <a:endParaRPr kumimoji="0" lang="en-US" altLang="ja-JP" sz="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Ken Arimura, K</a:t>
            </a:r>
            <a:r>
              <a:rPr kumimoji="0" lang="en-US" altLang="ja-JP" sz="1200" b="1" i="0" u="none" strike="noStrike" cap="none" normalizeH="0" baseline="0" dirty="0" bmk="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enzo Hiroshima, Yoji Nagashima, Tadao Nakazawa, Akira </a:t>
            </a:r>
            <a:r>
              <a:rPr kumimoji="0" lang="en-US" altLang="ja-JP" sz="1200" b="1" i="0" u="none" strike="noStrike" cap="none" normalizeH="0" baseline="0" dirty="0" err="1" bmk="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Ogihara</a:t>
            </a:r>
            <a:r>
              <a:rPr kumimoji="0" lang="en-US" altLang="ja-JP" sz="1200" b="1" i="0" u="none" strike="noStrike" cap="none" normalizeH="0" baseline="0" dirty="0" bmk="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Mami </a:t>
            </a:r>
            <a:r>
              <a:rPr kumimoji="0" lang="en-US" altLang="ja-JP" sz="1200" b="1" i="0" u="none" strike="noStrike" cap="none" normalizeH="0" baseline="0" dirty="0" err="1" bmk="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Orimo</a:t>
            </a:r>
            <a:r>
              <a:rPr kumimoji="0" lang="en-US" altLang="ja-JP" sz="1200" b="1" i="0" u="none" strike="noStrike" cap="none" normalizeH="0" baseline="0" dirty="0" bmk="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</a:t>
            </a:r>
            <a:r>
              <a:rPr kumimoji="0" lang="en-US" altLang="ja-JP" sz="1200" b="1" i="0" u="none" strike="noStrike" cap="none" normalizeH="0" baseline="0" dirty="0" err="1" bmk="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Yasuto</a:t>
            </a:r>
            <a:r>
              <a:rPr kumimoji="0" lang="en-US" altLang="ja-JP" sz="1200" b="1" i="0" u="none" strike="noStrike" cap="none" normalizeH="0" baseline="0" dirty="0" bmk="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Sato, Hideki Katsura, Masato </a:t>
            </a:r>
            <a:r>
              <a:rPr kumimoji="0" lang="en-US" altLang="ja-JP" sz="1200" b="1" i="0" u="none" strike="noStrike" cap="none" normalizeH="0" baseline="0" dirty="0" err="1" bmk="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Kanzaki</a:t>
            </a:r>
            <a:r>
              <a:rPr kumimoji="0" lang="en-US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itsuko Kondo, Etsuko Tagaya</a:t>
            </a:r>
            <a:endParaRPr kumimoji="0" lang="en-US" altLang="ja-JP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* Correspondence: </a:t>
            </a: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Ken Arimura: </a:t>
            </a:r>
            <a:r>
              <a:rPr kumimoji="0" lang="en-GB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  <a:hlinkClick r:id="rId8"/>
              </a:rPr>
              <a:t>arimura.ken@twmu.ac.jp</a:t>
            </a:r>
            <a:r>
              <a:rPr kumimoji="0" lang="en-GB" altLang="ja-JP" sz="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  <a:endParaRPr kumimoji="0" lang="en-GB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872738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3944</TotalTime>
  <Words>120</Words>
  <Application>Microsoft Office PowerPoint</Application>
  <PresentationFormat>ワイド画面</PresentationFormat>
  <Paragraphs>19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LAG3 expression in various human cancers</dc:title>
  <dc:creator>有村 健</dc:creator>
  <cp:lastModifiedBy>健</cp:lastModifiedBy>
  <cp:revision>8</cp:revision>
  <dcterms:created xsi:type="dcterms:W3CDTF">2022-09-01T02:13:08Z</dcterms:created>
  <dcterms:modified xsi:type="dcterms:W3CDTF">2023-03-30T02:33:11Z</dcterms:modified>
</cp:coreProperties>
</file>